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58" r:id="rId2"/>
    <p:sldId id="258" r:id="rId3"/>
    <p:sldId id="257" r:id="rId4"/>
    <p:sldId id="259" r:id="rId5"/>
    <p:sldId id="35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359" autoAdjust="0"/>
    <p:restoredTop sz="94660"/>
  </p:normalViewPr>
  <p:slideViewPr>
    <p:cSldViewPr snapToGrid="0">
      <p:cViewPr varScale="1">
        <p:scale>
          <a:sx n="83" d="100"/>
          <a:sy n="83" d="100"/>
        </p:scale>
        <p:origin x="114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/>
              <a:t>Female Mice</a:t>
            </a:r>
          </a:p>
        </c:rich>
      </c:tx>
      <c:layout>
        <c:manualLayout>
          <c:xMode val="edge"/>
          <c:yMode val="edge"/>
          <c:x val="0.37321363034748856"/>
          <c:y val="2.31481481481481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3.6889948588033676E-2"/>
          <c:y val="2.3264071157771946E-2"/>
          <c:w val="0.91226879694579566"/>
          <c:h val="0.79361111111111116"/>
        </c:manualLayout>
      </c:layout>
      <c:scatterChart>
        <c:scatterStyle val="lineMarker"/>
        <c:varyColors val="0"/>
        <c:ser>
          <c:idx val="0"/>
          <c:order val="0"/>
          <c:tx>
            <c:v>LFD</c:v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[Chart in Microsoft PowerPoint]Daily Food consumption'!$I$125:$AW$125</c:f>
                <c:numCache>
                  <c:formatCode>General</c:formatCode>
                  <c:ptCount val="41"/>
                  <c:pt idx="0">
                    <c:v>0.35954747178877083</c:v>
                  </c:pt>
                  <c:pt idx="1">
                    <c:v>0.35221471907535873</c:v>
                  </c:pt>
                  <c:pt idx="2">
                    <c:v>0.48</c:v>
                  </c:pt>
                  <c:pt idx="3">
                    <c:v>0.31708333333333333</c:v>
                  </c:pt>
                  <c:pt idx="4">
                    <c:v>0.20100000000000004</c:v>
                  </c:pt>
                  <c:pt idx="5">
                    <c:v>0.19861111111111113</c:v>
                  </c:pt>
                  <c:pt idx="6">
                    <c:v>0.19035714285714289</c:v>
                  </c:pt>
                  <c:pt idx="7">
                    <c:v>0.18035714285714291</c:v>
                  </c:pt>
                  <c:pt idx="8">
                    <c:v>0.20750000000000002</c:v>
                  </c:pt>
                  <c:pt idx="9">
                    <c:v>0.15031249999999996</c:v>
                  </c:pt>
                  <c:pt idx="10">
                    <c:v>0.16750000000000004</c:v>
                  </c:pt>
                  <c:pt idx="11">
                    <c:v>0.20178571428571429</c:v>
                  </c:pt>
                  <c:pt idx="12">
                    <c:v>0.20214285714285715</c:v>
                  </c:pt>
                  <c:pt idx="13">
                    <c:v>0.19035714285714289</c:v>
                  </c:pt>
                  <c:pt idx="14">
                    <c:v>0.19142857142857142</c:v>
                  </c:pt>
                  <c:pt idx="15">
                    <c:v>0.20571428571428574</c:v>
                  </c:pt>
                  <c:pt idx="16">
                    <c:v>0.17750000000000002</c:v>
                  </c:pt>
                  <c:pt idx="17">
                    <c:v>0.2282142857142857</c:v>
                  </c:pt>
                  <c:pt idx="18">
                    <c:v>0.20771428571428574</c:v>
                  </c:pt>
                  <c:pt idx="19">
                    <c:v>0.1772857142857143</c:v>
                  </c:pt>
                  <c:pt idx="20">
                    <c:v>0.18857142857142858</c:v>
                  </c:pt>
                  <c:pt idx="21">
                    <c:v>0.21214285714285716</c:v>
                  </c:pt>
                  <c:pt idx="22">
                    <c:v>0.20464285714285718</c:v>
                  </c:pt>
                  <c:pt idx="23">
                    <c:v>0.19250000000000003</c:v>
                  </c:pt>
                  <c:pt idx="24">
                    <c:v>0.20428571428571432</c:v>
                  </c:pt>
                  <c:pt idx="25">
                    <c:v>0.1907142857142857</c:v>
                  </c:pt>
                  <c:pt idx="26">
                    <c:v>0.20303571428571432</c:v>
                  </c:pt>
                  <c:pt idx="27">
                    <c:v>0.17357142857142857</c:v>
                  </c:pt>
                  <c:pt idx="28">
                    <c:v>0.20535714285714285</c:v>
                  </c:pt>
                  <c:pt idx="29">
                    <c:v>0.22708333333333336</c:v>
                  </c:pt>
                  <c:pt idx="30">
                    <c:v>0.24875000000000003</c:v>
                  </c:pt>
                  <c:pt idx="31">
                    <c:v>0.24208333333333332</c:v>
                  </c:pt>
                  <c:pt idx="32">
                    <c:v>0.23041666666666669</c:v>
                  </c:pt>
                  <c:pt idx="33">
                    <c:v>0.23416666666666663</c:v>
                  </c:pt>
                  <c:pt idx="34">
                    <c:v>0.22875000000000012</c:v>
                  </c:pt>
                  <c:pt idx="35">
                    <c:v>0.22874999999999998</c:v>
                  </c:pt>
                  <c:pt idx="36">
                    <c:v>0.20375000000000001</c:v>
                  </c:pt>
                  <c:pt idx="37">
                    <c:v>0.22645833333333332</c:v>
                  </c:pt>
                  <c:pt idx="38">
                    <c:v>0.25166666666666671</c:v>
                  </c:pt>
                  <c:pt idx="39">
                    <c:v>0.23000000000000009</c:v>
                  </c:pt>
                  <c:pt idx="40">
                    <c:v>0.2412500000000000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[Chart in Microsoft PowerPoint]Daily Food consumption'!$I$116:$AW$116</c:f>
              <c:numCache>
                <c:formatCode>General</c:formatCode>
                <c:ptCount val="41"/>
                <c:pt idx="0">
                  <c:v>-1</c:v>
                </c:pt>
                <c:pt idx="1">
                  <c:v>0</c:v>
                </c:pt>
                <c:pt idx="2">
                  <c:v>1</c:v>
                </c:pt>
                <c:pt idx="3" formatCode="0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'[Chart in Microsoft PowerPoint]Daily Food consumption'!$I$119:$AW$119</c:f>
              <c:numCache>
                <c:formatCode>0.00</c:formatCode>
                <c:ptCount val="41"/>
                <c:pt idx="0">
                  <c:v>0.75104166666666661</c:v>
                </c:pt>
                <c:pt idx="1">
                  <c:v>3.1708333333333329</c:v>
                </c:pt>
                <c:pt idx="2">
                  <c:v>2.0100000000000002</c:v>
                </c:pt>
                <c:pt idx="3">
                  <c:v>1.9861111111111112</c:v>
                </c:pt>
                <c:pt idx="4">
                  <c:v>1.9035714285714289</c:v>
                </c:pt>
                <c:pt idx="5">
                  <c:v>1.803571428571429</c:v>
                </c:pt>
                <c:pt idx="6">
                  <c:v>2.0750000000000002</c:v>
                </c:pt>
                <c:pt idx="7">
                  <c:v>1.5031249999999996</c:v>
                </c:pt>
                <c:pt idx="8">
                  <c:v>1.6750000000000003</c:v>
                </c:pt>
                <c:pt idx="9">
                  <c:v>2.0178571428571428</c:v>
                </c:pt>
                <c:pt idx="10">
                  <c:v>2.0214285714285714</c:v>
                </c:pt>
                <c:pt idx="11">
                  <c:v>1.9035714285714289</c:v>
                </c:pt>
                <c:pt idx="12">
                  <c:v>1.9142857142857141</c:v>
                </c:pt>
                <c:pt idx="13">
                  <c:v>2.0571428571428574</c:v>
                </c:pt>
                <c:pt idx="14">
                  <c:v>1.7750000000000001</c:v>
                </c:pt>
                <c:pt idx="15">
                  <c:v>2.282142857142857</c:v>
                </c:pt>
                <c:pt idx="16">
                  <c:v>2.0771428571428574</c:v>
                </c:pt>
                <c:pt idx="17">
                  <c:v>1.7728571428571429</c:v>
                </c:pt>
                <c:pt idx="18">
                  <c:v>1.8857142857142857</c:v>
                </c:pt>
                <c:pt idx="19">
                  <c:v>2.1214285714285714</c:v>
                </c:pt>
                <c:pt idx="20">
                  <c:v>2.0464285714285717</c:v>
                </c:pt>
                <c:pt idx="21">
                  <c:v>1.9250000000000003</c:v>
                </c:pt>
                <c:pt idx="22">
                  <c:v>2.0428571428571431</c:v>
                </c:pt>
                <c:pt idx="23">
                  <c:v>1.9071428571428568</c:v>
                </c:pt>
                <c:pt idx="24">
                  <c:v>2.030357142857143</c:v>
                </c:pt>
                <c:pt idx="25">
                  <c:v>1.7357142857142855</c:v>
                </c:pt>
                <c:pt idx="26">
                  <c:v>2.0535714285714284</c:v>
                </c:pt>
                <c:pt idx="27">
                  <c:v>2.2708333333333335</c:v>
                </c:pt>
                <c:pt idx="28">
                  <c:v>2.4875000000000003</c:v>
                </c:pt>
                <c:pt idx="29">
                  <c:v>2.4208333333333329</c:v>
                </c:pt>
                <c:pt idx="30">
                  <c:v>2.3041666666666667</c:v>
                </c:pt>
                <c:pt idx="31">
                  <c:v>2.3416666666666663</c:v>
                </c:pt>
                <c:pt idx="32">
                  <c:v>2.287500000000001</c:v>
                </c:pt>
                <c:pt idx="33">
                  <c:v>2.2874999999999996</c:v>
                </c:pt>
                <c:pt idx="34">
                  <c:v>2.0375000000000001</c:v>
                </c:pt>
                <c:pt idx="35">
                  <c:v>2.2645833333333329</c:v>
                </c:pt>
                <c:pt idx="36">
                  <c:v>2.5166666666666671</c:v>
                </c:pt>
                <c:pt idx="37">
                  <c:v>2.3000000000000007</c:v>
                </c:pt>
                <c:pt idx="38">
                  <c:v>2.4125000000000001</c:v>
                </c:pt>
                <c:pt idx="39">
                  <c:v>2.3708333333333331</c:v>
                </c:pt>
                <c:pt idx="40">
                  <c:v>2.15416666666666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CCA-4423-9E37-57EA2BA1F136}"/>
            </c:ext>
          </c:extLst>
        </c:ser>
        <c:ser>
          <c:idx val="1"/>
          <c:order val="1"/>
          <c:tx>
            <c:v>WD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19050">
                  <a:solidFill>
                    <a:schemeClr val="tx1"/>
                  </a:solidFill>
                </a:ln>
                <a:effectLst/>
              </c:spPr>
            </c:marker>
            <c:bubble3D val="0"/>
            <c:spPr>
              <a:ln w="19050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CCCA-4423-9E37-57EA2BA1F136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rgbClr val="FF0000"/>
                </a:solidFill>
                <a:ln w="19050">
                  <a:solidFill>
                    <a:schemeClr val="tx1"/>
                  </a:solidFill>
                </a:ln>
                <a:effectLst/>
              </c:spPr>
            </c:marker>
            <c:bubble3D val="0"/>
            <c:spPr>
              <a:ln w="19050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CCCA-4423-9E37-57EA2BA1F136}"/>
              </c:ext>
            </c:extLst>
          </c:dPt>
          <c:errBars>
            <c:errDir val="y"/>
            <c:errBarType val="plus"/>
            <c:errValType val="cust"/>
            <c:noEndCap val="0"/>
            <c:plus>
              <c:numRef>
                <c:f>'[Chart in Microsoft PowerPoint]Daily Food consumption'!$I$126:$AW$126</c:f>
                <c:numCache>
                  <c:formatCode>General</c:formatCode>
                  <c:ptCount val="41"/>
                  <c:pt idx="0">
                    <c:v>0.48775731359939373</c:v>
                  </c:pt>
                  <c:pt idx="1">
                    <c:v>0.35</c:v>
                  </c:pt>
                  <c:pt idx="2">
                    <c:v>0.46200278936490585</c:v>
                  </c:pt>
                  <c:pt idx="3">
                    <c:v>0.24722763671170622</c:v>
                  </c:pt>
                  <c:pt idx="4">
                    <c:v>9.2876261277530514E-2</c:v>
                  </c:pt>
                  <c:pt idx="5">
                    <c:v>0.44608589909699942</c:v>
                  </c:pt>
                  <c:pt idx="6">
                    <c:v>6.0020395838969919E-2</c:v>
                  </c:pt>
                  <c:pt idx="7">
                    <c:v>8.5446133128811913E-2</c:v>
                  </c:pt>
                  <c:pt idx="8">
                    <c:v>0.1235842745524959</c:v>
                  </c:pt>
                  <c:pt idx="9">
                    <c:v>0.18193783979980749</c:v>
                  </c:pt>
                  <c:pt idx="10">
                    <c:v>6.5802347827352128E-2</c:v>
                  </c:pt>
                  <c:pt idx="11">
                    <c:v>0.5999466728002425</c:v>
                  </c:pt>
                  <c:pt idx="12">
                    <c:v>0.23754424220932568</c:v>
                  </c:pt>
                  <c:pt idx="13">
                    <c:v>0.15145085612081507</c:v>
                  </c:pt>
                  <c:pt idx="14">
                    <c:v>0.24882265287757435</c:v>
                  </c:pt>
                  <c:pt idx="15">
                    <c:v>0.23248756458588227</c:v>
                  </c:pt>
                  <c:pt idx="16">
                    <c:v>0.17632973904236432</c:v>
                  </c:pt>
                  <c:pt idx="17">
                    <c:v>0.27732957321005414</c:v>
                  </c:pt>
                  <c:pt idx="18">
                    <c:v>0.18854888032578951</c:v>
                  </c:pt>
                  <c:pt idx="19">
                    <c:v>0.20688612990797448</c:v>
                  </c:pt>
                  <c:pt idx="20">
                    <c:v>0.28409384228541618</c:v>
                  </c:pt>
                  <c:pt idx="21">
                    <c:v>0.19498680837989235</c:v>
                  </c:pt>
                  <c:pt idx="22">
                    <c:v>0.27130847907193528</c:v>
                  </c:pt>
                  <c:pt idx="23">
                    <c:v>0.26037673843561299</c:v>
                  </c:pt>
                  <c:pt idx="24">
                    <c:v>0.27450895398206354</c:v>
                  </c:pt>
                  <c:pt idx="25">
                    <c:v>7.3236059480036281E-2</c:v>
                  </c:pt>
                  <c:pt idx="26">
                    <c:v>9.0711698500788723E-2</c:v>
                  </c:pt>
                  <c:pt idx="27">
                    <c:v>0.34559843930492573</c:v>
                  </c:pt>
                  <c:pt idx="28">
                    <c:v>0.34913397321085682</c:v>
                  </c:pt>
                  <c:pt idx="29">
                    <c:v>0.27989643421967614</c:v>
                  </c:pt>
                  <c:pt idx="30">
                    <c:v>0.16499158227686175</c:v>
                  </c:pt>
                  <c:pt idx="31">
                    <c:v>0.11195857368786963</c:v>
                  </c:pt>
                  <c:pt idx="32">
                    <c:v>2.0623947784607407E-2</c:v>
                  </c:pt>
                  <c:pt idx="33">
                    <c:v>1.0694990065446544</c:v>
                  </c:pt>
                  <c:pt idx="34">
                    <c:v>1.131370849898476</c:v>
                  </c:pt>
                  <c:pt idx="35">
                    <c:v>0.17736595094762639</c:v>
                  </c:pt>
                  <c:pt idx="36">
                    <c:v>0.18856180831641201</c:v>
                  </c:pt>
                  <c:pt idx="37">
                    <c:v>0.32998316455372256</c:v>
                  </c:pt>
                  <c:pt idx="38">
                    <c:v>0.1001734606680942</c:v>
                  </c:pt>
                  <c:pt idx="39">
                    <c:v>0.10901229543292679</c:v>
                  </c:pt>
                  <c:pt idx="40">
                    <c:v>1.17851130197757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xVal>
            <c:numRef>
              <c:f>'[Chart in Microsoft PowerPoint]Daily Food consumption'!$I$116:$AW$116</c:f>
              <c:numCache>
                <c:formatCode>General</c:formatCode>
                <c:ptCount val="41"/>
                <c:pt idx="0">
                  <c:v>-1</c:v>
                </c:pt>
                <c:pt idx="1">
                  <c:v>0</c:v>
                </c:pt>
                <c:pt idx="2">
                  <c:v>1</c:v>
                </c:pt>
                <c:pt idx="3" formatCode="0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'[Chart in Microsoft PowerPoint]Daily Food consumption'!$I$120:$AW$120</c:f>
              <c:numCache>
                <c:formatCode>General</c:formatCode>
                <c:ptCount val="41"/>
                <c:pt idx="0">
                  <c:v>0.75</c:v>
                </c:pt>
                <c:pt idx="1">
                  <c:v>3.17</c:v>
                </c:pt>
                <c:pt idx="2" formatCode="0.00">
                  <c:v>2.0735416666666664</c:v>
                </c:pt>
                <c:pt idx="3" formatCode="0.00">
                  <c:v>2.1122569444444443</c:v>
                </c:pt>
                <c:pt idx="4" formatCode="0.00">
                  <c:v>2.0667410714285714</c:v>
                </c:pt>
                <c:pt idx="5" formatCode="0.00">
                  <c:v>1.8358035714285714</c:v>
                </c:pt>
                <c:pt idx="6" formatCode="0.00">
                  <c:v>2.0158333333333331</c:v>
                </c:pt>
                <c:pt idx="7" formatCode="0.00">
                  <c:v>1.5627083333333334</c:v>
                </c:pt>
                <c:pt idx="8" formatCode="0.00">
                  <c:v>1.8729166666666666</c:v>
                </c:pt>
                <c:pt idx="9" formatCode="0.00">
                  <c:v>2.2446428571428574</c:v>
                </c:pt>
                <c:pt idx="10" formatCode="0.00">
                  <c:v>2.211071428571429</c:v>
                </c:pt>
                <c:pt idx="11" formatCode="0.00">
                  <c:v>2.0451428571428569</c:v>
                </c:pt>
                <c:pt idx="12" formatCode="0.00">
                  <c:v>2.3731785714285714</c:v>
                </c:pt>
                <c:pt idx="13" formatCode="0.00">
                  <c:v>2.445267857142857</c:v>
                </c:pt>
                <c:pt idx="14" formatCode="0.00">
                  <c:v>2.3298214285714285</c:v>
                </c:pt>
                <c:pt idx="15" formatCode="0.00">
                  <c:v>2.3898214285714285</c:v>
                </c:pt>
                <c:pt idx="16" formatCode="0.00">
                  <c:v>2.3935714285714287</c:v>
                </c:pt>
                <c:pt idx="17" formatCode="0.00">
                  <c:v>2.4841071428571428</c:v>
                </c:pt>
                <c:pt idx="18" formatCode="0.00">
                  <c:v>2.3942857142857141</c:v>
                </c:pt>
                <c:pt idx="19" formatCode="0.00">
                  <c:v>2.4017857142857144</c:v>
                </c:pt>
                <c:pt idx="20" formatCode="0.00">
                  <c:v>2.4162499999999998</c:v>
                </c:pt>
                <c:pt idx="21" formatCode="0.00">
                  <c:v>2.4916071428571427</c:v>
                </c:pt>
                <c:pt idx="22" formatCode="0.00">
                  <c:v>2.545178571428572</c:v>
                </c:pt>
                <c:pt idx="23" formatCode="0.00">
                  <c:v>2.4358928571428571</c:v>
                </c:pt>
                <c:pt idx="24" formatCode="0.00">
                  <c:v>2.4112499999999999</c:v>
                </c:pt>
                <c:pt idx="25" formatCode="0.00">
                  <c:v>2.3375000000000004</c:v>
                </c:pt>
                <c:pt idx="26" formatCode="0.00">
                  <c:v>2.214428571428571</c:v>
                </c:pt>
                <c:pt idx="27" formatCode="0.00">
                  <c:v>2.9068750000000003</c:v>
                </c:pt>
                <c:pt idx="28" formatCode="0.00">
                  <c:v>3.0593750000000006</c:v>
                </c:pt>
                <c:pt idx="29" formatCode="0.00">
                  <c:v>3.0270833333333336</c:v>
                </c:pt>
                <c:pt idx="30" formatCode="0.00">
                  <c:v>2.5291666666666668</c:v>
                </c:pt>
                <c:pt idx="31" formatCode="0.00">
                  <c:v>2.7625000000000002</c:v>
                </c:pt>
                <c:pt idx="32" formatCode="0.00">
                  <c:v>2.4354166666666659</c:v>
                </c:pt>
                <c:pt idx="33" formatCode="0.00">
                  <c:v>3.3770833333333332</c:v>
                </c:pt>
                <c:pt idx="34" formatCode="0.00">
                  <c:v>1.2958333333333334</c:v>
                </c:pt>
                <c:pt idx="35" formatCode="0.00">
                  <c:v>2.6629166666666668</c:v>
                </c:pt>
                <c:pt idx="36" formatCode="0.00">
                  <c:v>3.0416666666666665</c:v>
                </c:pt>
                <c:pt idx="37" formatCode="0.00">
                  <c:v>2.8041666666666663</c:v>
                </c:pt>
                <c:pt idx="38" formatCode="0.00">
                  <c:v>2.7312500000000002</c:v>
                </c:pt>
                <c:pt idx="39" formatCode="0.00">
                  <c:v>2.7895833333333329</c:v>
                </c:pt>
                <c:pt idx="40" formatCode="0.00">
                  <c:v>2.34583333333333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CCA-4423-9E37-57EA2BA1F1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5314968"/>
        <c:axId val="314532056"/>
      </c:scatterChart>
      <c:valAx>
        <c:axId val="315314968"/>
        <c:scaling>
          <c:orientation val="minMax"/>
          <c:min val="-5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4532056"/>
        <c:crosses val="autoZero"/>
        <c:crossBetween val="midCat"/>
        <c:majorUnit val="5"/>
      </c:valAx>
      <c:valAx>
        <c:axId val="314532056"/>
        <c:scaling>
          <c:orientation val="minMax"/>
          <c:max val="6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5314968"/>
        <c:crossesAt val="-10"/>
        <c:crossBetween val="midCat"/>
        <c:majorUnit val="1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33134213971707449"/>
          <c:y val="0.15324074074074076"/>
          <c:w val="0.33425158156549262"/>
          <c:h val="0.1849515164771070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/>
              <a:t>Male Mic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0781034061368231E-2"/>
          <c:y val="2.3264071157771946E-2"/>
          <c:w val="0.91476081498433592"/>
          <c:h val="0.79361111111111116"/>
        </c:manualLayout>
      </c:layout>
      <c:scatterChart>
        <c:scatterStyle val="lineMarker"/>
        <c:varyColors val="0"/>
        <c:ser>
          <c:idx val="0"/>
          <c:order val="0"/>
          <c:tx>
            <c:v>LFD</c:v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[Chart in Microsoft PowerPoint]Daily Food consumption'!$I$128:$AW$128</c:f>
                <c:numCache>
                  <c:formatCode>General</c:formatCode>
                  <c:ptCount val="41"/>
                  <c:pt idx="0">
                    <c:v>0.36</c:v>
                  </c:pt>
                  <c:pt idx="1">
                    <c:v>1.08</c:v>
                  </c:pt>
                  <c:pt idx="2">
                    <c:v>0.23299999999999998</c:v>
                  </c:pt>
                  <c:pt idx="3">
                    <c:v>0.21388888888888885</c:v>
                  </c:pt>
                  <c:pt idx="4">
                    <c:v>0.21892857142857136</c:v>
                  </c:pt>
                  <c:pt idx="5">
                    <c:v>0.21892857142857142</c:v>
                  </c:pt>
                  <c:pt idx="6">
                    <c:v>0.22250000000000006</c:v>
                  </c:pt>
                  <c:pt idx="7">
                    <c:v>0.17624999999999999</c:v>
                  </c:pt>
                  <c:pt idx="8">
                    <c:v>0.20156250000000001</c:v>
                  </c:pt>
                  <c:pt idx="9">
                    <c:v>0.23214285714285718</c:v>
                  </c:pt>
                  <c:pt idx="10">
                    <c:v>0.2207142857142857</c:v>
                  </c:pt>
                  <c:pt idx="11">
                    <c:v>0.22367857142857145</c:v>
                  </c:pt>
                  <c:pt idx="12">
                    <c:v>0.21060714285714283</c:v>
                  </c:pt>
                  <c:pt idx="13">
                    <c:v>0.22785714285714287</c:v>
                  </c:pt>
                  <c:pt idx="14">
                    <c:v>0.22321428571428573</c:v>
                  </c:pt>
                  <c:pt idx="15">
                    <c:v>0.31035714285714283</c:v>
                  </c:pt>
                  <c:pt idx="16">
                    <c:v>0.2080714285714286</c:v>
                  </c:pt>
                  <c:pt idx="17">
                    <c:v>0.15657142857142858</c:v>
                  </c:pt>
                  <c:pt idx="18">
                    <c:v>0.23075000000000001</c:v>
                  </c:pt>
                  <c:pt idx="19">
                    <c:v>0.24460714285714286</c:v>
                  </c:pt>
                  <c:pt idx="20">
                    <c:v>0.24107142857142852</c:v>
                  </c:pt>
                  <c:pt idx="21">
                    <c:v>0.2392857142857143</c:v>
                  </c:pt>
                  <c:pt idx="22">
                    <c:v>0.23535714285714288</c:v>
                  </c:pt>
                  <c:pt idx="23">
                    <c:v>0.22892857142857148</c:v>
                  </c:pt>
                  <c:pt idx="24">
                    <c:v>0.24410714285714286</c:v>
                  </c:pt>
                  <c:pt idx="25">
                    <c:v>0.24232142857142863</c:v>
                  </c:pt>
                  <c:pt idx="26">
                    <c:v>0.23039285714285712</c:v>
                  </c:pt>
                  <c:pt idx="27">
                    <c:v>0.28283333333333338</c:v>
                  </c:pt>
                  <c:pt idx="28">
                    <c:v>0.2927083333333334</c:v>
                  </c:pt>
                  <c:pt idx="29">
                    <c:v>0.29854166666666665</c:v>
                  </c:pt>
                  <c:pt idx="30">
                    <c:v>0.28958333333333336</c:v>
                  </c:pt>
                  <c:pt idx="31">
                    <c:v>0.32583333333333342</c:v>
                  </c:pt>
                  <c:pt idx="32">
                    <c:v>0.28849999999999998</c:v>
                  </c:pt>
                  <c:pt idx="33">
                    <c:v>0.3048333333333334</c:v>
                  </c:pt>
                  <c:pt idx="34">
                    <c:v>0.26125000000000004</c:v>
                  </c:pt>
                  <c:pt idx="35">
                    <c:v>0.30916666666666659</c:v>
                  </c:pt>
                  <c:pt idx="36">
                    <c:v>0.30833333333333329</c:v>
                  </c:pt>
                  <c:pt idx="37">
                    <c:v>0.32274999999999998</c:v>
                  </c:pt>
                  <c:pt idx="38">
                    <c:v>0.30820833333333336</c:v>
                  </c:pt>
                  <c:pt idx="39">
                    <c:v>0.30958333333333332</c:v>
                  </c:pt>
                  <c:pt idx="40">
                    <c:v>0.28333333333333344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[Chart in Microsoft PowerPoint]Daily Food consumption'!$I$116:$AW$116</c:f>
              <c:numCache>
                <c:formatCode>General</c:formatCode>
                <c:ptCount val="41"/>
                <c:pt idx="0">
                  <c:v>-1</c:v>
                </c:pt>
                <c:pt idx="1">
                  <c:v>0</c:v>
                </c:pt>
                <c:pt idx="2">
                  <c:v>1</c:v>
                </c:pt>
                <c:pt idx="3" formatCode="0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'[Chart in Microsoft PowerPoint]Daily Food consumption'!$I$122:$AW$122</c:f>
              <c:numCache>
                <c:formatCode>0.00</c:formatCode>
                <c:ptCount val="41"/>
                <c:pt idx="0">
                  <c:v>1.2416666666666665</c:v>
                </c:pt>
                <c:pt idx="1">
                  <c:v>3.8597916666666663</c:v>
                </c:pt>
                <c:pt idx="2">
                  <c:v>2.3299999999999996</c:v>
                </c:pt>
                <c:pt idx="3">
                  <c:v>2.1388888888888884</c:v>
                </c:pt>
                <c:pt idx="4">
                  <c:v>2.1892857142857136</c:v>
                </c:pt>
                <c:pt idx="5">
                  <c:v>2.1892857142857141</c:v>
                </c:pt>
                <c:pt idx="6">
                  <c:v>2.2250000000000005</c:v>
                </c:pt>
                <c:pt idx="7">
                  <c:v>1.7624999999999997</c:v>
                </c:pt>
                <c:pt idx="8">
                  <c:v>2.015625</c:v>
                </c:pt>
                <c:pt idx="9">
                  <c:v>2.3214285714285716</c:v>
                </c:pt>
                <c:pt idx="10">
                  <c:v>2.2071428571428569</c:v>
                </c:pt>
                <c:pt idx="11">
                  <c:v>2.2367857142857144</c:v>
                </c:pt>
                <c:pt idx="12">
                  <c:v>2.1060714285714282</c:v>
                </c:pt>
                <c:pt idx="13">
                  <c:v>2.2785714285714285</c:v>
                </c:pt>
                <c:pt idx="14">
                  <c:v>2.2321428571428572</c:v>
                </c:pt>
                <c:pt idx="15">
                  <c:v>3.1035714285714282</c:v>
                </c:pt>
                <c:pt idx="16">
                  <c:v>2.080714285714286</c:v>
                </c:pt>
                <c:pt idx="17">
                  <c:v>1.5657142857142858</c:v>
                </c:pt>
                <c:pt idx="18">
                  <c:v>2.3075000000000001</c:v>
                </c:pt>
                <c:pt idx="19">
                  <c:v>2.4460714285714285</c:v>
                </c:pt>
                <c:pt idx="20">
                  <c:v>2.4107142857142851</c:v>
                </c:pt>
                <c:pt idx="21">
                  <c:v>2.3928571428571428</c:v>
                </c:pt>
                <c:pt idx="22">
                  <c:v>2.3535714285714286</c:v>
                </c:pt>
                <c:pt idx="23">
                  <c:v>2.2892857142857146</c:v>
                </c:pt>
                <c:pt idx="24">
                  <c:v>2.4410714285714286</c:v>
                </c:pt>
                <c:pt idx="25">
                  <c:v>2.4232142857142862</c:v>
                </c:pt>
                <c:pt idx="26">
                  <c:v>2.3039285714285711</c:v>
                </c:pt>
                <c:pt idx="27">
                  <c:v>2.8283333333333336</c:v>
                </c:pt>
                <c:pt idx="28">
                  <c:v>2.9270833333333339</c:v>
                </c:pt>
                <c:pt idx="29">
                  <c:v>2.9854166666666662</c:v>
                </c:pt>
                <c:pt idx="30">
                  <c:v>2.8958333333333335</c:v>
                </c:pt>
                <c:pt idx="31">
                  <c:v>3.2583333333333342</c:v>
                </c:pt>
                <c:pt idx="32">
                  <c:v>2.8849999999999998</c:v>
                </c:pt>
                <c:pt idx="33">
                  <c:v>3.0483333333333338</c:v>
                </c:pt>
                <c:pt idx="34">
                  <c:v>2.6125000000000003</c:v>
                </c:pt>
                <c:pt idx="35">
                  <c:v>3.0916666666666655</c:v>
                </c:pt>
                <c:pt idx="36">
                  <c:v>3.0833333333333326</c:v>
                </c:pt>
                <c:pt idx="37">
                  <c:v>3.2274999999999996</c:v>
                </c:pt>
                <c:pt idx="38">
                  <c:v>3.0820833333333333</c:v>
                </c:pt>
                <c:pt idx="39">
                  <c:v>3.0958333333333332</c:v>
                </c:pt>
                <c:pt idx="40">
                  <c:v>2.83333333333333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8CB-4E19-9844-2002BBE20FD4}"/>
            </c:ext>
          </c:extLst>
        </c:ser>
        <c:ser>
          <c:idx val="1"/>
          <c:order val="1"/>
          <c:tx>
            <c:v>WD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19050">
                  <a:solidFill>
                    <a:schemeClr val="tx1"/>
                  </a:solidFill>
                </a:ln>
                <a:effectLst/>
              </c:spPr>
            </c:marker>
            <c:bubble3D val="0"/>
            <c:spPr>
              <a:ln w="19050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B8CB-4E19-9844-2002BBE20FD4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rgbClr val="FF0000"/>
                </a:solidFill>
                <a:ln w="19050">
                  <a:solidFill>
                    <a:schemeClr val="tx1"/>
                  </a:solidFill>
                </a:ln>
                <a:effectLst/>
              </c:spPr>
            </c:marker>
            <c:bubble3D val="0"/>
            <c:spPr>
              <a:ln w="19050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B8CB-4E19-9844-2002BBE20FD4}"/>
              </c:ext>
            </c:extLst>
          </c:dPt>
          <c:errBars>
            <c:errDir val="y"/>
            <c:errBarType val="plus"/>
            <c:errValType val="cust"/>
            <c:noEndCap val="0"/>
            <c:plus>
              <c:numRef>
                <c:f>'[Chart in Microsoft PowerPoint]Daily Food consumption'!$I$129:$AW$129</c:f>
                <c:numCache>
                  <c:formatCode>General</c:formatCode>
                  <c:ptCount val="41"/>
                  <c:pt idx="0">
                    <c:v>0.49</c:v>
                  </c:pt>
                  <c:pt idx="1">
                    <c:v>1.08</c:v>
                  </c:pt>
                  <c:pt idx="2">
                    <c:v>0.54663377332804641</c:v>
                  </c:pt>
                  <c:pt idx="3">
                    <c:v>0.20273079201241834</c:v>
                  </c:pt>
                  <c:pt idx="4">
                    <c:v>0.25661254840712672</c:v>
                  </c:pt>
                  <c:pt idx="5">
                    <c:v>0.25034027498563532</c:v>
                  </c:pt>
                  <c:pt idx="6">
                    <c:v>0.32737465794814785</c:v>
                  </c:pt>
                  <c:pt idx="7">
                    <c:v>0.28485239233095178</c:v>
                  </c:pt>
                  <c:pt idx="8">
                    <c:v>0.29403986142046407</c:v>
                  </c:pt>
                  <c:pt idx="9">
                    <c:v>0.31868693186922009</c:v>
                  </c:pt>
                  <c:pt idx="10">
                    <c:v>0.34512779847313202</c:v>
                  </c:pt>
                  <c:pt idx="11">
                    <c:v>0.68455543508724181</c:v>
                  </c:pt>
                  <c:pt idx="12">
                    <c:v>0.32453084596536141</c:v>
                  </c:pt>
                  <c:pt idx="13">
                    <c:v>0.43979277742458411</c:v>
                  </c:pt>
                  <c:pt idx="14">
                    <c:v>0.3457575730475394</c:v>
                  </c:pt>
                  <c:pt idx="15">
                    <c:v>0.37368289104697355</c:v>
                  </c:pt>
                  <c:pt idx="16">
                    <c:v>0.34582218652636887</c:v>
                  </c:pt>
                  <c:pt idx="17">
                    <c:v>0.39301338884257164</c:v>
                  </c:pt>
                  <c:pt idx="18">
                    <c:v>0.45387279077301074</c:v>
                  </c:pt>
                  <c:pt idx="19">
                    <c:v>0.37744593476876859</c:v>
                  </c:pt>
                  <c:pt idx="20">
                    <c:v>0.34629888343260201</c:v>
                  </c:pt>
                  <c:pt idx="21">
                    <c:v>0.33871374093667939</c:v>
                  </c:pt>
                  <c:pt idx="22">
                    <c:v>0.45693833780700338</c:v>
                  </c:pt>
                  <c:pt idx="23">
                    <c:v>0.30034185454551088</c:v>
                  </c:pt>
                  <c:pt idx="24">
                    <c:v>0.14849242404917495</c:v>
                  </c:pt>
                  <c:pt idx="25">
                    <c:v>0.11187439430915729</c:v>
                  </c:pt>
                  <c:pt idx="26">
                    <c:v>0.20127289450202787</c:v>
                  </c:pt>
                  <c:pt idx="27">
                    <c:v>0.17930207665801773</c:v>
                  </c:pt>
                  <c:pt idx="28">
                    <c:v>0.61972858608278181</c:v>
                  </c:pt>
                  <c:pt idx="29">
                    <c:v>0.7010458659192349</c:v>
                  </c:pt>
                  <c:pt idx="30">
                    <c:v>0.58033263684524483</c:v>
                  </c:pt>
                  <c:pt idx="31">
                    <c:v>0.60053568773628885</c:v>
                  </c:pt>
                  <c:pt idx="32">
                    <c:v>0.64397224715203427</c:v>
                  </c:pt>
                  <c:pt idx="33">
                    <c:v>0.22728432252424724</c:v>
                  </c:pt>
                  <c:pt idx="34">
                    <c:v>0.22980970388562744</c:v>
                  </c:pt>
                  <c:pt idx="35">
                    <c:v>0.39774756441743392</c:v>
                  </c:pt>
                  <c:pt idx="36">
                    <c:v>0.4242640687119289</c:v>
                  </c:pt>
                  <c:pt idx="37">
                    <c:v>0.3653385036130492</c:v>
                  </c:pt>
                  <c:pt idx="38">
                    <c:v>0.11004349282215592</c:v>
                  </c:pt>
                  <c:pt idx="39">
                    <c:v>0.54211519890968785</c:v>
                  </c:pt>
                  <c:pt idx="40">
                    <c:v>0.477297077300916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xVal>
            <c:numRef>
              <c:f>'[Chart in Microsoft PowerPoint]Daily Food consumption'!$I$116:$AW$116</c:f>
              <c:numCache>
                <c:formatCode>General</c:formatCode>
                <c:ptCount val="41"/>
                <c:pt idx="0">
                  <c:v>-1</c:v>
                </c:pt>
                <c:pt idx="1">
                  <c:v>0</c:v>
                </c:pt>
                <c:pt idx="2">
                  <c:v>1</c:v>
                </c:pt>
                <c:pt idx="3" formatCode="0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'[Chart in Microsoft PowerPoint]Daily Food consumption'!$I$123:$AW$123</c:f>
              <c:numCache>
                <c:formatCode>General</c:formatCode>
                <c:ptCount val="41"/>
                <c:pt idx="0" formatCode="0.00">
                  <c:v>1.24</c:v>
                </c:pt>
                <c:pt idx="1">
                  <c:v>3.86</c:v>
                </c:pt>
                <c:pt idx="2" formatCode="0.00">
                  <c:v>2.5697916666666667</c:v>
                </c:pt>
                <c:pt idx="3" formatCode="0.00">
                  <c:v>2.6200694444444448</c:v>
                </c:pt>
                <c:pt idx="4" formatCode="0.00">
                  <c:v>2.5453571428571427</c:v>
                </c:pt>
                <c:pt idx="5" formatCode="0.00">
                  <c:v>2.6152678571428569</c:v>
                </c:pt>
                <c:pt idx="6" formatCode="0.00">
                  <c:v>2.6154166666666665</c:v>
                </c:pt>
                <c:pt idx="7" formatCode="0.00">
                  <c:v>2.0658333333333334</c:v>
                </c:pt>
                <c:pt idx="8" formatCode="0.00">
                  <c:v>2.3363541666666667</c:v>
                </c:pt>
                <c:pt idx="9" formatCode="0.00">
                  <c:v>2.6154761904761901</c:v>
                </c:pt>
                <c:pt idx="10" formatCode="0.00">
                  <c:v>2.718809523809524</c:v>
                </c:pt>
                <c:pt idx="11" formatCode="0.00">
                  <c:v>2.2602976190476194</c:v>
                </c:pt>
                <c:pt idx="12" formatCode="0.00">
                  <c:v>2.7829464285714285</c:v>
                </c:pt>
                <c:pt idx="13" formatCode="0.00">
                  <c:v>2.6185714285714288</c:v>
                </c:pt>
                <c:pt idx="14" formatCode="0.00">
                  <c:v>2.9400000000000004</c:v>
                </c:pt>
                <c:pt idx="15" formatCode="0.00">
                  <c:v>2.5758928571428572</c:v>
                </c:pt>
                <c:pt idx="16" formatCode="0.00">
                  <c:v>2.8719642857142857</c:v>
                </c:pt>
                <c:pt idx="17" formatCode="0.00">
                  <c:v>2.7964285714285717</c:v>
                </c:pt>
                <c:pt idx="18" formatCode="0.00">
                  <c:v>2.7253571428571428</c:v>
                </c:pt>
                <c:pt idx="19" formatCode="0.00">
                  <c:v>2.7844642857142858</c:v>
                </c:pt>
                <c:pt idx="20" formatCode="0.00">
                  <c:v>2.7619642857142854</c:v>
                </c:pt>
                <c:pt idx="21" formatCode="0.00">
                  <c:v>2.9266071428571427</c:v>
                </c:pt>
                <c:pt idx="22" formatCode="0.00">
                  <c:v>2.9187499999999997</c:v>
                </c:pt>
                <c:pt idx="23" formatCode="0.00">
                  <c:v>2.8191071428571433</c:v>
                </c:pt>
                <c:pt idx="24" formatCode="0.00">
                  <c:v>2.1692857142857145</c:v>
                </c:pt>
                <c:pt idx="25" formatCode="0.00">
                  <c:v>2.9562499999999998</c:v>
                </c:pt>
                <c:pt idx="26" formatCode="0.00">
                  <c:v>2.8551785714285716</c:v>
                </c:pt>
                <c:pt idx="27" formatCode="0.00">
                  <c:v>2.9796428571428573</c:v>
                </c:pt>
                <c:pt idx="28" formatCode="0.00">
                  <c:v>2.5867857142857145</c:v>
                </c:pt>
                <c:pt idx="29" formatCode="0.00">
                  <c:v>2.5757142857142856</c:v>
                </c:pt>
                <c:pt idx="30" formatCode="0.00">
                  <c:v>2.4503571428571425</c:v>
                </c:pt>
                <c:pt idx="31" formatCode="0.00">
                  <c:v>2.7360714285714285</c:v>
                </c:pt>
                <c:pt idx="32" formatCode="0.00">
                  <c:v>2.5267857142857144</c:v>
                </c:pt>
                <c:pt idx="33" formatCode="0.00">
                  <c:v>2.8892857142857142</c:v>
                </c:pt>
                <c:pt idx="34" formatCode="0.00">
                  <c:v>2.9541666666666675</c:v>
                </c:pt>
                <c:pt idx="35" formatCode="0.00">
                  <c:v>3.3937499999999998</c:v>
                </c:pt>
                <c:pt idx="36" formatCode="0.00">
                  <c:v>3.5958333333333332</c:v>
                </c:pt>
                <c:pt idx="37" formatCode="0.00">
                  <c:v>3.4041666666666668</c:v>
                </c:pt>
                <c:pt idx="38" formatCode="0.00">
                  <c:v>3.1513541666666667</c:v>
                </c:pt>
                <c:pt idx="39" formatCode="0.00">
                  <c:v>3.0708333333333329</c:v>
                </c:pt>
                <c:pt idx="40" formatCode="0.00">
                  <c:v>2.71666666666666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8CB-4E19-9844-2002BBE20F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5314968"/>
        <c:axId val="314532056"/>
      </c:scatterChart>
      <c:valAx>
        <c:axId val="315314968"/>
        <c:scaling>
          <c:orientation val="minMax"/>
          <c:min val="-5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4532056"/>
        <c:crosses val="autoZero"/>
        <c:crossBetween val="midCat"/>
        <c:majorUnit val="5"/>
      </c:valAx>
      <c:valAx>
        <c:axId val="314532056"/>
        <c:scaling>
          <c:orientation val="minMax"/>
          <c:max val="6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5314968"/>
        <c:crossesAt val="-10"/>
        <c:crossBetween val="midCat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33507534383540338"/>
          <c:y val="0.10694444444444444"/>
          <c:w val="0.31923371919923565"/>
          <c:h val="0.2173589238845144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/>
              <a:t>Female Mice</a:t>
            </a:r>
          </a:p>
        </c:rich>
      </c:tx>
      <c:layout>
        <c:manualLayout>
          <c:xMode val="edge"/>
          <c:yMode val="edge"/>
          <c:x val="0.24667814165506957"/>
          <c:y val="4.05749333373584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2903049991598415"/>
          <c:y val="2.3264071157771946E-2"/>
          <c:w val="0.73306056898133998"/>
          <c:h val="0.80668125531937518"/>
        </c:manualLayout>
      </c:layout>
      <c:scatterChart>
        <c:scatterStyle val="lineMarker"/>
        <c:varyColors val="0"/>
        <c:ser>
          <c:idx val="0"/>
          <c:order val="0"/>
          <c:tx>
            <c:v>LFD</c:v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Daily Food consumption'!$I$156:$AW$156</c:f>
                <c:numCache>
                  <c:formatCode>General</c:formatCode>
                  <c:ptCount val="41"/>
                  <c:pt idx="0">
                    <c:v>1.4586840930470435</c:v>
                  </c:pt>
                  <c:pt idx="1">
                    <c:v>1.7673918229507459</c:v>
                  </c:pt>
                  <c:pt idx="2">
                    <c:v>5.7470129850746261</c:v>
                  </c:pt>
                  <c:pt idx="3">
                    <c:v>5.1284912319784377</c:v>
                  </c:pt>
                  <c:pt idx="4">
                    <c:v>4.2073849851000622</c:v>
                  </c:pt>
                  <c:pt idx="5">
                    <c:v>5.1936536163289926</c:v>
                  </c:pt>
                  <c:pt idx="6">
                    <c:v>5.0989498413944894</c:v>
                  </c:pt>
                  <c:pt idx="7">
                    <c:v>7.4008194075079832</c:v>
                  </c:pt>
                  <c:pt idx="8">
                    <c:v>8.4827333387822783</c:v>
                  </c:pt>
                  <c:pt idx="9">
                    <c:v>5.7106050263888868</c:v>
                  </c:pt>
                  <c:pt idx="10">
                    <c:v>7.0318892284059684</c:v>
                  </c:pt>
                  <c:pt idx="11">
                    <c:v>9.8143836762559911</c:v>
                  </c:pt>
                  <c:pt idx="12">
                    <c:v>10.596819362887942</c:v>
                  </c:pt>
                  <c:pt idx="13">
                    <c:v>10.058277560984347</c:v>
                  </c:pt>
                  <c:pt idx="14">
                    <c:v>12.499316006387531</c:v>
                  </c:pt>
                  <c:pt idx="15">
                    <c:v>11.281772355019006</c:v>
                  </c:pt>
                  <c:pt idx="16">
                    <c:v>11.415287641945589</c:v>
                  </c:pt>
                  <c:pt idx="17">
                    <c:v>18.121727459422122</c:v>
                  </c:pt>
                  <c:pt idx="18">
                    <c:v>16.349453973833576</c:v>
                  </c:pt>
                  <c:pt idx="19">
                    <c:v>13.123143836898082</c:v>
                  </c:pt>
                  <c:pt idx="20">
                    <c:v>15.235145255214825</c:v>
                  </c:pt>
                  <c:pt idx="21">
                    <c:v>19.08136025072886</c:v>
                  </c:pt>
                  <c:pt idx="22">
                    <c:v>18.175073929487183</c:v>
                  </c:pt>
                  <c:pt idx="23">
                    <c:v>19.094208876820648</c:v>
                  </c:pt>
                  <c:pt idx="24">
                    <c:v>19.862333786963749</c:v>
                  </c:pt>
                  <c:pt idx="25">
                    <c:v>22.464234881491279</c:v>
                  </c:pt>
                  <c:pt idx="26">
                    <c:v>21.03757656584887</c:v>
                  </c:pt>
                  <c:pt idx="27">
                    <c:v>16.968130488822318</c:v>
                  </c:pt>
                  <c:pt idx="28">
                    <c:v>19.159980410413748</c:v>
                  </c:pt>
                  <c:pt idx="29">
                    <c:v>22.691792278843273</c:v>
                  </c:pt>
                  <c:pt idx="30">
                    <c:v>27.124635705265657</c:v>
                  </c:pt>
                  <c:pt idx="31">
                    <c:v>26.957070773378813</c:v>
                  </c:pt>
                  <c:pt idx="32">
                    <c:v>27.200300190548464</c:v>
                  </c:pt>
                  <c:pt idx="33">
                    <c:v>28.59299555380634</c:v>
                  </c:pt>
                  <c:pt idx="34">
                    <c:v>32.286819662868844</c:v>
                  </c:pt>
                  <c:pt idx="35">
                    <c:v>29.97726564078723</c:v>
                  </c:pt>
                  <c:pt idx="36">
                    <c:v>24.853148615470271</c:v>
                  </c:pt>
                  <c:pt idx="37">
                    <c:v>31.143996002489132</c:v>
                  </c:pt>
                  <c:pt idx="38">
                    <c:v>34.017843177385743</c:v>
                  </c:pt>
                  <c:pt idx="39">
                    <c:v>32.568647023935078</c:v>
                  </c:pt>
                  <c:pt idx="40">
                    <c:v>38.576420813403786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Daily Food consumption'!$I$116:$AW$116</c:f>
              <c:numCache>
                <c:formatCode>General</c:formatCode>
                <c:ptCount val="41"/>
                <c:pt idx="0">
                  <c:v>-1</c:v>
                </c:pt>
                <c:pt idx="1">
                  <c:v>0</c:v>
                </c:pt>
                <c:pt idx="2">
                  <c:v>1</c:v>
                </c:pt>
                <c:pt idx="3" formatCode="0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'Daily Food consumption'!$I$150:$AW$150</c:f>
              <c:numCache>
                <c:formatCode>0.00</c:formatCode>
                <c:ptCount val="41"/>
                <c:pt idx="0">
                  <c:v>3.0469760416666669</c:v>
                </c:pt>
                <c:pt idx="1">
                  <c:v>15.911046875</c:v>
                </c:pt>
                <c:pt idx="2">
                  <c:v>24.065616875</c:v>
                </c:pt>
                <c:pt idx="3">
                  <c:v>32.123269652777779</c:v>
                </c:pt>
                <c:pt idx="4">
                  <c:v>39.846058938492064</c:v>
                </c:pt>
                <c:pt idx="5">
                  <c:v>47.163148224206353</c:v>
                </c:pt>
                <c:pt idx="6">
                  <c:v>55.581423224206347</c:v>
                </c:pt>
                <c:pt idx="7">
                  <c:v>61.679601349206344</c:v>
                </c:pt>
                <c:pt idx="8">
                  <c:v>68.475076349206347</c:v>
                </c:pt>
                <c:pt idx="9">
                  <c:v>76.661522777777776</c:v>
                </c:pt>
                <c:pt idx="10">
                  <c:v>84.862458492063482</c:v>
                </c:pt>
                <c:pt idx="11">
                  <c:v>92.585247777777781</c:v>
                </c:pt>
                <c:pt idx="12">
                  <c:v>100.35150492063492</c:v>
                </c:pt>
                <c:pt idx="13">
                  <c:v>108.69733349206349</c:v>
                </c:pt>
                <c:pt idx="14">
                  <c:v>115.89850849206348</c:v>
                </c:pt>
                <c:pt idx="15">
                  <c:v>125.15716206349207</c:v>
                </c:pt>
                <c:pt idx="16">
                  <c:v>133.58413063492063</c:v>
                </c:pt>
                <c:pt idx="17">
                  <c:v>140.77661206349205</c:v>
                </c:pt>
                <c:pt idx="18">
                  <c:v>148.42695492063493</c:v>
                </c:pt>
                <c:pt idx="19">
                  <c:v>157.03359063492064</c:v>
                </c:pt>
                <c:pt idx="20">
                  <c:v>165.33595134920634</c:v>
                </c:pt>
                <c:pt idx="21">
                  <c:v>173.14567634920635</c:v>
                </c:pt>
                <c:pt idx="22">
                  <c:v>181.43354777777779</c:v>
                </c:pt>
                <c:pt idx="23">
                  <c:v>189.17082634920635</c:v>
                </c:pt>
                <c:pt idx="24">
                  <c:v>197.40798527777778</c:v>
                </c:pt>
                <c:pt idx="25">
                  <c:v>204.44977813492065</c:v>
                </c:pt>
                <c:pt idx="26">
                  <c:v>212.78111742063493</c:v>
                </c:pt>
                <c:pt idx="27">
                  <c:v>221.99388825396829</c:v>
                </c:pt>
                <c:pt idx="28">
                  <c:v>232.08567575396827</c:v>
                </c:pt>
                <c:pt idx="29">
                  <c:v>241.90699658730162</c:v>
                </c:pt>
                <c:pt idx="30">
                  <c:v>251.25500075396829</c:v>
                </c:pt>
                <c:pt idx="31">
                  <c:v>260.75514242063497</c:v>
                </c:pt>
                <c:pt idx="32">
                  <c:v>270.03552992063493</c:v>
                </c:pt>
                <c:pt idx="33">
                  <c:v>279.31591742063489</c:v>
                </c:pt>
                <c:pt idx="34">
                  <c:v>287.5820549206349</c:v>
                </c:pt>
                <c:pt idx="35">
                  <c:v>296.76946950396825</c:v>
                </c:pt>
                <c:pt idx="36">
                  <c:v>306.97958617063489</c:v>
                </c:pt>
                <c:pt idx="37">
                  <c:v>316.31068617063488</c:v>
                </c:pt>
                <c:pt idx="38">
                  <c:v>326.09819867063487</c:v>
                </c:pt>
                <c:pt idx="39">
                  <c:v>335.71666950396821</c:v>
                </c:pt>
                <c:pt idx="40">
                  <c:v>344.45612367063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8BC-45AA-B69E-63E6F2D56CA6}"/>
            </c:ext>
          </c:extLst>
        </c:ser>
        <c:ser>
          <c:idx val="1"/>
          <c:order val="1"/>
          <c:tx>
            <c:v>WD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Daily Food consumption'!$I$157:$AW$157</c:f>
                <c:numCache>
                  <c:formatCode>General</c:formatCode>
                  <c:ptCount val="41"/>
                  <c:pt idx="0">
                    <c:v>2.2856307715267592</c:v>
                  </c:pt>
                  <c:pt idx="1">
                    <c:v>2.0281362776025236</c:v>
                  </c:pt>
                  <c:pt idx="2">
                    <c:v>6.2577418614047868</c:v>
                  </c:pt>
                  <c:pt idx="3">
                    <c:v>4.4457840613392889</c:v>
                  </c:pt>
                  <c:pt idx="4">
                    <c:v>2.1421522356579255</c:v>
                  </c:pt>
                  <c:pt idx="5">
                    <c:v>13.673436015015749</c:v>
                  </c:pt>
                  <c:pt idx="6">
                    <c:v>1.9566983953272152</c:v>
                  </c:pt>
                  <c:pt idx="7">
                    <c:v>3.9937060723509141</c:v>
                  </c:pt>
                  <c:pt idx="8">
                    <c:v>5.3986645931772008</c:v>
                  </c:pt>
                  <c:pt idx="9">
                    <c:v>7.4841461910667704</c:v>
                  </c:pt>
                  <c:pt idx="10">
                    <c:v>3.056276197627247</c:v>
                  </c:pt>
                  <c:pt idx="11">
                    <c:v>32.937454853724589</c:v>
                  </c:pt>
                  <c:pt idx="12">
                    <c:v>12.351807713252764</c:v>
                  </c:pt>
                  <c:pt idx="13">
                    <c:v>8.3526611605070791</c:v>
                  </c:pt>
                  <c:pt idx="14">
                    <c:v>15.568780333049366</c:v>
                  </c:pt>
                  <c:pt idx="15">
                    <c:v>15.270917727347355</c:v>
                  </c:pt>
                  <c:pt idx="16">
                    <c:v>12.390333076938459</c:v>
                  </c:pt>
                  <c:pt idx="17">
                    <c:v>20.076716064036031</c:v>
                  </c:pt>
                  <c:pt idx="18">
                    <c:v>15.045220836129003</c:v>
                  </c:pt>
                  <c:pt idx="19">
                    <c:v>17.426355953205913</c:v>
                  </c:pt>
                  <c:pt idx="20">
                    <c:v>25.11770198082499</c:v>
                  </c:pt>
                  <c:pt idx="21">
                    <c:v>17.631757930770664</c:v>
                  </c:pt>
                  <c:pt idx="22">
                    <c:v>25.288147022692353</c:v>
                  </c:pt>
                  <c:pt idx="23">
                    <c:v>26.578178081077382</c:v>
                  </c:pt>
                  <c:pt idx="24">
                    <c:v>29.59345557097512</c:v>
                  </c:pt>
                  <c:pt idx="25">
                    <c:v>8.4875027776385039</c:v>
                  </c:pt>
                  <c:pt idx="26">
                    <c:v>11.522141882562766</c:v>
                  </c:pt>
                  <c:pt idx="27">
                    <c:v>35.060301503733143</c:v>
                  </c:pt>
                  <c:pt idx="28">
                    <c:v>35.289494539310517</c:v>
                  </c:pt>
                  <c:pt idx="29">
                    <c:v>29.904548941919458</c:v>
                  </c:pt>
                  <c:pt idx="30">
                    <c:v>21.871506041466073</c:v>
                  </c:pt>
                  <c:pt idx="31">
                    <c:v>14.112446493852872</c:v>
                  </c:pt>
                  <c:pt idx="32">
                    <c:v>3.04544685285929</c:v>
                  </c:pt>
                  <c:pt idx="33">
                    <c:v>118.90311816032849</c:v>
                  </c:pt>
                  <c:pt idx="34">
                    <c:v>98.406000000000006</c:v>
                  </c:pt>
                  <c:pt idx="35">
                    <c:v>26.242915391305143</c:v>
                  </c:pt>
                  <c:pt idx="36">
                    <c:v>25.30899139746505</c:v>
                  </c:pt>
                  <c:pt idx="37">
                    <c:v>49.588257290765547</c:v>
                  </c:pt>
                  <c:pt idx="38">
                    <c:v>15.924878992941306</c:v>
                  </c:pt>
                  <c:pt idx="39">
                    <c:v>17.478456826401974</c:v>
                  </c:pt>
                  <c:pt idx="40">
                    <c:v>2.30222745817454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xVal>
            <c:numRef>
              <c:f>'Daily Food consumption'!$I$116:$AW$116</c:f>
              <c:numCache>
                <c:formatCode>General</c:formatCode>
                <c:ptCount val="41"/>
                <c:pt idx="0">
                  <c:v>-1</c:v>
                </c:pt>
                <c:pt idx="1">
                  <c:v>0</c:v>
                </c:pt>
                <c:pt idx="2">
                  <c:v>1</c:v>
                </c:pt>
                <c:pt idx="3" formatCode="0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'Daily Food consumption'!$I$151:$AW$151</c:f>
              <c:numCache>
                <c:formatCode>0.00</c:formatCode>
                <c:ptCount val="41"/>
                <c:pt idx="0">
                  <c:v>3.5145</c:v>
                </c:pt>
                <c:pt idx="1">
                  <c:v>18.369119999999999</c:v>
                </c:pt>
                <c:pt idx="2">
                  <c:v>28.085736249999997</c:v>
                </c:pt>
                <c:pt idx="3">
                  <c:v>37.983772291666661</c:v>
                </c:pt>
                <c:pt idx="4">
                  <c:v>47.668520952380952</c:v>
                </c:pt>
                <c:pt idx="5">
                  <c:v>56.271096488095232</c:v>
                </c:pt>
                <c:pt idx="6">
                  <c:v>65.717291488095228</c:v>
                </c:pt>
                <c:pt idx="7">
                  <c:v>73.040142738095227</c:v>
                </c:pt>
                <c:pt idx="8">
                  <c:v>81.816630238095215</c:v>
                </c:pt>
                <c:pt idx="9">
                  <c:v>92.33502666666665</c:v>
                </c:pt>
                <c:pt idx="10">
                  <c:v>102.69610738095237</c:v>
                </c:pt>
                <c:pt idx="11">
                  <c:v>112.2796468095238</c:v>
                </c:pt>
                <c:pt idx="12">
                  <c:v>123.40036159523808</c:v>
                </c:pt>
                <c:pt idx="13">
                  <c:v>134.8588867738095</c:v>
                </c:pt>
                <c:pt idx="14">
                  <c:v>145.7764299880952</c:v>
                </c:pt>
                <c:pt idx="15">
                  <c:v>156.97513320238093</c:v>
                </c:pt>
                <c:pt idx="16">
                  <c:v>168.19140891666663</c:v>
                </c:pt>
                <c:pt idx="17">
                  <c:v>179.83193498809521</c:v>
                </c:pt>
                <c:pt idx="18">
                  <c:v>191.05155784523805</c:v>
                </c:pt>
                <c:pt idx="19">
                  <c:v>202.30632570238092</c:v>
                </c:pt>
                <c:pt idx="20">
                  <c:v>213.6288732023809</c:v>
                </c:pt>
                <c:pt idx="21">
                  <c:v>225.30454427380948</c:v>
                </c:pt>
                <c:pt idx="22">
                  <c:v>237.23125105952377</c:v>
                </c:pt>
                <c:pt idx="23">
                  <c:v>248.64584498809521</c:v>
                </c:pt>
                <c:pt idx="24">
                  <c:v>259.9449624880952</c:v>
                </c:pt>
                <c:pt idx="25">
                  <c:v>270.89848748809521</c:v>
                </c:pt>
                <c:pt idx="26">
                  <c:v>281.27529977380948</c:v>
                </c:pt>
                <c:pt idx="27">
                  <c:v>294.89691602380947</c:v>
                </c:pt>
                <c:pt idx="28">
                  <c:v>309.23314727380949</c:v>
                </c:pt>
                <c:pt idx="29">
                  <c:v>323.41805977380955</c:v>
                </c:pt>
                <c:pt idx="30">
                  <c:v>335.26973477380955</c:v>
                </c:pt>
                <c:pt idx="31">
                  <c:v>348.21480977380952</c:v>
                </c:pt>
                <c:pt idx="32">
                  <c:v>359.62717227380955</c:v>
                </c:pt>
                <c:pt idx="33">
                  <c:v>375.45218477380956</c:v>
                </c:pt>
                <c:pt idx="34">
                  <c:v>381.52445977380955</c:v>
                </c:pt>
                <c:pt idx="35">
                  <c:v>394.00288727380951</c:v>
                </c:pt>
                <c:pt idx="36">
                  <c:v>408.25613727380954</c:v>
                </c:pt>
                <c:pt idx="37">
                  <c:v>421.3964622738095</c:v>
                </c:pt>
                <c:pt idx="38">
                  <c:v>434.19509977380955</c:v>
                </c:pt>
                <c:pt idx="39">
                  <c:v>447.26708727380947</c:v>
                </c:pt>
                <c:pt idx="40">
                  <c:v>458.259662273809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8BC-45AA-B69E-63E6F2D56C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5314968"/>
        <c:axId val="314532056"/>
      </c:scatterChart>
      <c:valAx>
        <c:axId val="315314968"/>
        <c:scaling>
          <c:orientation val="minMax"/>
          <c:min val="-5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4532056"/>
        <c:crosses val="autoZero"/>
        <c:crossBetween val="midCat"/>
        <c:majorUnit val="5"/>
      </c:valAx>
      <c:valAx>
        <c:axId val="314532056"/>
        <c:scaling>
          <c:orientation val="minMax"/>
          <c:max val="700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5314968"/>
        <c:crossesAt val="-10"/>
        <c:crossBetween val="midCat"/>
        <c:majorUnit val="100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4628633686487228"/>
          <c:y val="0.15120611480795004"/>
          <c:w val="0.21447959706849232"/>
          <c:h val="0.150097888510355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/>
              <a:t>Male Mice</a:t>
            </a:r>
          </a:p>
        </c:rich>
      </c:tx>
      <c:layout>
        <c:manualLayout>
          <c:xMode val="edge"/>
          <c:yMode val="edge"/>
          <c:x val="0.2596905815789548"/>
          <c:y val="2.55574937959351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1399020956502335"/>
          <c:y val="3.0633272443441443E-2"/>
          <c:w val="0.74701440363412086"/>
          <c:h val="0.79361111111111116"/>
        </c:manualLayout>
      </c:layout>
      <c:scatterChart>
        <c:scatterStyle val="lineMarker"/>
        <c:varyColors val="0"/>
        <c:ser>
          <c:idx val="0"/>
          <c:order val="0"/>
          <c:tx>
            <c:v>LFD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Daily Food consumption'!$I$159:$AW$159</c:f>
                <c:numCache>
                  <c:formatCode>General</c:formatCode>
                  <c:ptCount val="41"/>
                  <c:pt idx="0">
                    <c:v>1.46052</c:v>
                  </c:pt>
                  <c:pt idx="1">
                    <c:v>5.7910757122038108</c:v>
                  </c:pt>
                  <c:pt idx="2">
                    <c:v>3.014942645833333</c:v>
                  </c:pt>
                  <c:pt idx="3">
                    <c:v>3.8826898680555555</c:v>
                  </c:pt>
                  <c:pt idx="4">
                    <c:v>4.7708830823412702</c:v>
                  </c:pt>
                  <c:pt idx="5">
                    <c:v>5.659076296626985</c:v>
                  </c:pt>
                  <c:pt idx="6">
                    <c:v>6.5617587966269841</c:v>
                  </c:pt>
                  <c:pt idx="7">
                    <c:v>7.2768050466269845</c:v>
                  </c:pt>
                  <c:pt idx="8">
                    <c:v>8.0945441091269839</c:v>
                  </c:pt>
                  <c:pt idx="9">
                    <c:v>9.036347680555556</c:v>
                  </c:pt>
                  <c:pt idx="10">
                    <c:v>9.9317855376984152</c:v>
                  </c:pt>
                  <c:pt idx="11">
                    <c:v>10.839249501984128</c:v>
                  </c:pt>
                  <c:pt idx="12">
                    <c:v>11.693682680555556</c:v>
                  </c:pt>
                  <c:pt idx="13">
                    <c:v>12.618099109126984</c:v>
                  </c:pt>
                  <c:pt idx="14">
                    <c:v>13.52367946626984</c:v>
                  </c:pt>
                  <c:pt idx="15">
                    <c:v>14.782798394841269</c:v>
                  </c:pt>
                  <c:pt idx="16">
                    <c:v>15.626944180555554</c:v>
                  </c:pt>
                  <c:pt idx="17">
                    <c:v>16.262154466269838</c:v>
                  </c:pt>
                  <c:pt idx="18">
                    <c:v>17.198307216269843</c:v>
                  </c:pt>
                  <c:pt idx="19">
                    <c:v>18.190678394841267</c:v>
                  </c:pt>
                  <c:pt idx="20">
                    <c:v>19.168705180555556</c:v>
                  </c:pt>
                  <c:pt idx="21">
                    <c:v>20.139487323412698</c:v>
                  </c:pt>
                  <c:pt idx="22">
                    <c:v>21.094331251984126</c:v>
                  </c:pt>
                  <c:pt idx="23">
                    <c:v>22.023094466269839</c:v>
                  </c:pt>
                  <c:pt idx="24">
                    <c:v>23.013437144841266</c:v>
                  </c:pt>
                  <c:pt idx="25">
                    <c:v>23.996535180555554</c:v>
                  </c:pt>
                  <c:pt idx="26">
                    <c:v>24.931239001984125</c:v>
                  </c:pt>
                  <c:pt idx="27">
                    <c:v>26.078693835317463</c:v>
                  </c:pt>
                  <c:pt idx="28">
                    <c:v>27.266211543650794</c:v>
                  </c:pt>
                  <c:pt idx="29">
                    <c:v>28.477395085317454</c:v>
                  </c:pt>
                  <c:pt idx="30">
                    <c:v>29.652234668650792</c:v>
                  </c:pt>
                  <c:pt idx="31">
                    <c:v>30.974140501984124</c:v>
                  </c:pt>
                  <c:pt idx="32">
                    <c:v>32.144585001984126</c:v>
                  </c:pt>
                  <c:pt idx="33">
                    <c:v>33.381293835317464</c:v>
                  </c:pt>
                  <c:pt idx="34">
                    <c:v>34.441185085317464</c:v>
                  </c:pt>
                  <c:pt idx="35">
                    <c:v>35.69547425198413</c:v>
                  </c:pt>
                  <c:pt idx="36">
                    <c:v>36.946382585317458</c:v>
                  </c:pt>
                  <c:pt idx="37">
                    <c:v>38.255779335317463</c:v>
                  </c:pt>
                  <c:pt idx="38">
                    <c:v>39.5061805436508</c:v>
                  </c:pt>
                  <c:pt idx="39">
                    <c:v>40.762160126984128</c:v>
                  </c:pt>
                  <c:pt idx="40">
                    <c:v>41.91164346031745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Daily Food consumption'!$I$116:$AW$116</c:f>
              <c:numCache>
                <c:formatCode>General</c:formatCode>
                <c:ptCount val="41"/>
                <c:pt idx="0">
                  <c:v>-1</c:v>
                </c:pt>
                <c:pt idx="1">
                  <c:v>0</c:v>
                </c:pt>
                <c:pt idx="2">
                  <c:v>1</c:v>
                </c:pt>
                <c:pt idx="3" formatCode="0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'Daily Food consumption'!$I$153:$AW$153</c:f>
              <c:numCache>
                <c:formatCode>0.00</c:formatCode>
                <c:ptCount val="41"/>
                <c:pt idx="0">
                  <c:v>5.0374416666666662</c:v>
                </c:pt>
                <c:pt idx="1">
                  <c:v>20.696616458333331</c:v>
                </c:pt>
                <c:pt idx="2">
                  <c:v>30.14942645833333</c:v>
                </c:pt>
                <c:pt idx="3">
                  <c:v>38.826898680555551</c:v>
                </c:pt>
                <c:pt idx="4">
                  <c:v>47.708830823412697</c:v>
                </c:pt>
                <c:pt idx="5">
                  <c:v>56.590762966269835</c:v>
                </c:pt>
                <c:pt idx="6">
                  <c:v>65.617587966269838</c:v>
                </c:pt>
                <c:pt idx="7">
                  <c:v>72.768050466269841</c:v>
                </c:pt>
                <c:pt idx="8">
                  <c:v>80.945441091269842</c:v>
                </c:pt>
                <c:pt idx="9">
                  <c:v>90.363476805555564</c:v>
                </c:pt>
                <c:pt idx="10">
                  <c:v>99.317855376984127</c:v>
                </c:pt>
                <c:pt idx="11">
                  <c:v>108.39249501984126</c:v>
                </c:pt>
                <c:pt idx="12">
                  <c:v>116.93682680555555</c:v>
                </c:pt>
                <c:pt idx="13">
                  <c:v>126.18099109126983</c:v>
                </c:pt>
                <c:pt idx="14">
                  <c:v>135.2367946626984</c:v>
                </c:pt>
                <c:pt idx="15">
                  <c:v>147.82798394841268</c:v>
                </c:pt>
                <c:pt idx="16">
                  <c:v>156.26944180555554</c:v>
                </c:pt>
                <c:pt idx="17">
                  <c:v>162.6215446626984</c:v>
                </c:pt>
                <c:pt idx="18">
                  <c:v>171.98307216269839</c:v>
                </c:pt>
                <c:pt idx="19">
                  <c:v>181.90678394841268</c:v>
                </c:pt>
                <c:pt idx="20">
                  <c:v>191.68705180555554</c:v>
                </c:pt>
                <c:pt idx="21">
                  <c:v>201.39487323412698</c:v>
                </c:pt>
                <c:pt idx="22">
                  <c:v>210.94331251984124</c:v>
                </c:pt>
                <c:pt idx="23">
                  <c:v>220.23094466269839</c:v>
                </c:pt>
                <c:pt idx="24">
                  <c:v>230.13437144841265</c:v>
                </c:pt>
                <c:pt idx="25">
                  <c:v>239.96535180555554</c:v>
                </c:pt>
                <c:pt idx="26">
                  <c:v>249.31239001984125</c:v>
                </c:pt>
                <c:pt idx="27">
                  <c:v>260.78693835317461</c:v>
                </c:pt>
                <c:pt idx="28">
                  <c:v>272.66211543650792</c:v>
                </c:pt>
                <c:pt idx="29">
                  <c:v>284.77395085317454</c:v>
                </c:pt>
                <c:pt idx="30">
                  <c:v>296.52234668650789</c:v>
                </c:pt>
                <c:pt idx="31">
                  <c:v>309.74140501984124</c:v>
                </c:pt>
                <c:pt idx="32">
                  <c:v>321.44585001984126</c:v>
                </c:pt>
                <c:pt idx="33">
                  <c:v>333.81293835317456</c:v>
                </c:pt>
                <c:pt idx="34">
                  <c:v>344.4118508531746</c:v>
                </c:pt>
                <c:pt idx="35">
                  <c:v>356.95474251984126</c:v>
                </c:pt>
                <c:pt idx="36">
                  <c:v>369.46382585317457</c:v>
                </c:pt>
                <c:pt idx="37">
                  <c:v>382.55779335317459</c:v>
                </c:pt>
                <c:pt idx="38">
                  <c:v>395.06180543650794</c:v>
                </c:pt>
                <c:pt idx="39">
                  <c:v>407.62160126984122</c:v>
                </c:pt>
                <c:pt idx="40">
                  <c:v>419.116434603174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8D2-4715-9990-4244BABBA47B}"/>
            </c:ext>
          </c:extLst>
        </c:ser>
        <c:ser>
          <c:idx val="1"/>
          <c:order val="1"/>
          <c:tx>
            <c:v>WD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Daily Food consumption'!$I$160:$AW$160</c:f>
                <c:numCache>
                  <c:formatCode>General</c:formatCode>
                  <c:ptCount val="41"/>
                  <c:pt idx="0">
                    <c:v>2.2961399999999998</c:v>
                  </c:pt>
                  <c:pt idx="1">
                    <c:v>6.6866549222797937</c:v>
                  </c:pt>
                  <c:pt idx="2">
                    <c:v>7.6451215729815587</c:v>
                  </c:pt>
                  <c:pt idx="3">
                    <c:v>3.7309438392824315</c:v>
                  </c:pt>
                  <c:pt idx="4">
                    <c:v>6.0636580836222747</c:v>
                  </c:pt>
                  <c:pt idx="5">
                    <c:v>6.9304108454452615</c:v>
                  </c:pt>
                  <c:pt idx="6">
                    <c:v>10.596589820698053</c:v>
                  </c:pt>
                  <c:pt idx="7">
                    <c:v>13.007927381613753</c:v>
                  </c:pt>
                  <c:pt idx="8">
                    <c:v>13.250613180299053</c:v>
                  </c:pt>
                  <c:pt idx="9">
                    <c:v>14.322045678627411</c:v>
                  </c:pt>
                  <c:pt idx="10">
                    <c:v>16.53809015804682</c:v>
                  </c:pt>
                  <c:pt idx="11">
                    <c:v>42.66511115143264</c:v>
                  </c:pt>
                  <c:pt idx="12">
                    <c:v>17.948612622409374</c:v>
                  </c:pt>
                  <c:pt idx="13">
                    <c:v>27.911039742530455</c:v>
                  </c:pt>
                  <c:pt idx="14">
                    <c:v>21.164366875166927</c:v>
                  </c:pt>
                  <c:pt idx="15">
                    <c:v>27.858039602115223</c:v>
                  </c:pt>
                  <c:pt idx="16">
                    <c:v>24.743776747597572</c:v>
                  </c:pt>
                  <c:pt idx="17">
                    <c:v>30.72156746324687</c:v>
                  </c:pt>
                  <c:pt idx="18">
                    <c:v>38.530963182121695</c:v>
                  </c:pt>
                  <c:pt idx="19">
                    <c:v>33.131324717642357</c:v>
                  </c:pt>
                  <c:pt idx="20">
                    <c:v>32.267693604939218</c:v>
                  </c:pt>
                  <c:pt idx="21">
                    <c:v>31.372601766814402</c:v>
                  </c:pt>
                  <c:pt idx="22">
                    <c:v>44.578034665135625</c:v>
                  </c:pt>
                  <c:pt idx="23">
                    <c:v>31.743833506797408</c:v>
                  </c:pt>
                  <c:pt idx="24">
                    <c:v>21.091724377390214</c:v>
                  </c:pt>
                  <c:pt idx="25">
                    <c:v>12.184660513178269</c:v>
                  </c:pt>
                  <c:pt idx="26">
                    <c:v>23.640554322486498</c:v>
                  </c:pt>
                  <c:pt idx="27">
                    <c:v>21.0204690154766</c:v>
                  </c:pt>
                  <c:pt idx="28">
                    <c:v>86.591890312325873</c:v>
                  </c:pt>
                  <c:pt idx="29">
                    <c:v>101.66013391476618</c:v>
                  </c:pt>
                  <c:pt idx="30">
                    <c:v>91.179969079681157</c:v>
                  </c:pt>
                  <c:pt idx="31">
                    <c:v>87.315377769722971</c:v>
                  </c:pt>
                  <c:pt idx="32">
                    <c:v>104.40367648233621</c:v>
                  </c:pt>
                  <c:pt idx="33">
                    <c:v>33.290285678874909</c:v>
                  </c:pt>
                  <c:pt idx="34">
                    <c:v>33.997803597723212</c:v>
                  </c:pt>
                  <c:pt idx="35">
                    <c:v>53.084505415771865</c:v>
                  </c:pt>
                  <c:pt idx="36">
                    <c:v>55.429374085569883</c:v>
                  </c:pt>
                  <c:pt idx="37">
                    <c:v>52.130242408783737</c:v>
                  </c:pt>
                  <c:pt idx="38">
                    <c:v>17.477476611766949</c:v>
                  </c:pt>
                  <c:pt idx="39">
                    <c:v>90.898562946266637</c:v>
                  </c:pt>
                  <c:pt idx="40">
                    <c:v>92.7002629473107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xVal>
            <c:numRef>
              <c:f>'Daily Food consumption'!$I$116:$AW$116</c:f>
              <c:numCache>
                <c:formatCode>General</c:formatCode>
                <c:ptCount val="41"/>
                <c:pt idx="0">
                  <c:v>-1</c:v>
                </c:pt>
                <c:pt idx="1">
                  <c:v>0</c:v>
                </c:pt>
                <c:pt idx="2">
                  <c:v>1</c:v>
                </c:pt>
                <c:pt idx="3" formatCode="0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'Daily Food consumption'!$I$154:$AW$154</c:f>
              <c:numCache>
                <c:formatCode>0.00</c:formatCode>
                <c:ptCount val="41"/>
                <c:pt idx="0">
                  <c:v>5.8106400000000002</c:v>
                </c:pt>
                <c:pt idx="1">
                  <c:v>23.898599999999998</c:v>
                </c:pt>
                <c:pt idx="2">
                  <c:v>35.94064375</c:v>
                </c:pt>
                <c:pt idx="3">
                  <c:v>48.218289166666665</c:v>
                </c:pt>
                <c:pt idx="4">
                  <c:v>60.145832738095237</c:v>
                </c:pt>
                <c:pt idx="5">
                  <c:v>72.400977916666662</c:v>
                </c:pt>
                <c:pt idx="6">
                  <c:v>84.656820416666676</c:v>
                </c:pt>
                <c:pt idx="7">
                  <c:v>94.337315416666669</c:v>
                </c:pt>
                <c:pt idx="8">
                  <c:v>105.28547104166667</c:v>
                </c:pt>
                <c:pt idx="9">
                  <c:v>117.5415924702381</c:v>
                </c:pt>
                <c:pt idx="10">
                  <c:v>130.28193389880954</c:v>
                </c:pt>
                <c:pt idx="11">
                  <c:v>140.8736885416667</c:v>
                </c:pt>
                <c:pt idx="12">
                  <c:v>153.9145755059524</c:v>
                </c:pt>
                <c:pt idx="13">
                  <c:v>166.1852012202381</c:v>
                </c:pt>
                <c:pt idx="14">
                  <c:v>179.96204122023809</c:v>
                </c:pt>
                <c:pt idx="15">
                  <c:v>192.03267514880952</c:v>
                </c:pt>
                <c:pt idx="16">
                  <c:v>205.49069979166666</c:v>
                </c:pt>
                <c:pt idx="17">
                  <c:v>218.59476407738094</c:v>
                </c:pt>
                <c:pt idx="18">
                  <c:v>231.36578764880949</c:v>
                </c:pt>
                <c:pt idx="19">
                  <c:v>244.41378729166664</c:v>
                </c:pt>
                <c:pt idx="20">
                  <c:v>257.35635193452379</c:v>
                </c:pt>
                <c:pt idx="21">
                  <c:v>271.07043300595234</c:v>
                </c:pt>
                <c:pt idx="22">
                  <c:v>284.74769550595238</c:v>
                </c:pt>
                <c:pt idx="23">
                  <c:v>297.95803157738095</c:v>
                </c:pt>
                <c:pt idx="24">
                  <c:v>308.12330443452385</c:v>
                </c:pt>
                <c:pt idx="25">
                  <c:v>321.97629193452383</c:v>
                </c:pt>
                <c:pt idx="26">
                  <c:v>335.35565872023807</c:v>
                </c:pt>
                <c:pt idx="27">
                  <c:v>349.31826514880953</c:v>
                </c:pt>
                <c:pt idx="28">
                  <c:v>361.43994300595239</c:v>
                </c:pt>
                <c:pt idx="29">
                  <c:v>373.5097401488095</c:v>
                </c:pt>
                <c:pt idx="30">
                  <c:v>384.99211372023808</c:v>
                </c:pt>
                <c:pt idx="31">
                  <c:v>397.8133444345238</c:v>
                </c:pt>
                <c:pt idx="32">
                  <c:v>409.65386229166666</c:v>
                </c:pt>
                <c:pt idx="33">
                  <c:v>423.19305514880955</c:v>
                </c:pt>
                <c:pt idx="34">
                  <c:v>437.03628014880951</c:v>
                </c:pt>
                <c:pt idx="35">
                  <c:v>452.93939264880953</c:v>
                </c:pt>
                <c:pt idx="36">
                  <c:v>469.78946764880953</c:v>
                </c:pt>
                <c:pt idx="37">
                  <c:v>485.74139264880949</c:v>
                </c:pt>
                <c:pt idx="38">
                  <c:v>500.50863827380948</c:v>
                </c:pt>
                <c:pt idx="39">
                  <c:v>514.89856327380949</c:v>
                </c:pt>
                <c:pt idx="40">
                  <c:v>527.628863273809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8D2-4715-9990-4244BABBA4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5314968"/>
        <c:axId val="314532056"/>
      </c:scatterChart>
      <c:valAx>
        <c:axId val="315314968"/>
        <c:scaling>
          <c:orientation val="minMax"/>
          <c:max val="45"/>
          <c:min val="-5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4532056"/>
        <c:crosses val="autoZero"/>
        <c:crossBetween val="midCat"/>
        <c:majorUnit val="5"/>
      </c:valAx>
      <c:valAx>
        <c:axId val="314532056"/>
        <c:scaling>
          <c:orientation val="minMax"/>
          <c:max val="700"/>
          <c:min val="0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5314968"/>
        <c:crossesAt val="-10"/>
        <c:crossBetween val="midCat"/>
        <c:majorUnit val="100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1221900170129027"/>
          <c:y val="0.14212314351807287"/>
          <c:w val="0.22278450762963969"/>
          <c:h val="0.123647959945168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1</cdr:y>
    </cdr:from>
    <cdr:to>
      <cdr:x>1</cdr:x>
      <cdr:y>1</cdr:y>
    </cdr:to>
    <cdr:cxnSp macro="">
      <cdr:nvCxnSpPr>
        <cdr:cNvPr id="2" name="Straight Connector 1">
          <a:extLst xmlns:a="http://schemas.openxmlformats.org/drawingml/2006/main">
            <a:ext uri="{FF2B5EF4-FFF2-40B4-BE49-F238E27FC236}">
              <a16:creationId xmlns:a16="http://schemas.microsoft.com/office/drawing/2014/main" id="{1875B922-5491-094F-979F-9B0CB2C6A24B}"/>
            </a:ext>
          </a:extLst>
        </cdr:cNvPr>
        <cdr:cNvCxnSpPr/>
      </cdr:nvCxnSpPr>
      <cdr:spPr>
        <a:xfrm xmlns:a="http://schemas.openxmlformats.org/drawingml/2006/main">
          <a:off x="410770" y="2958832"/>
          <a:ext cx="12074161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7268D6-7831-4974-910F-A0230C84E2E5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8AD86B-A98D-4652-ACF5-3F441EF95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1855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679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244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145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341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229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9354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80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980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65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517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523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DDEA1B-930C-4BAC-902F-9C8C8EE0A183}" type="datetimeFigureOut">
              <a:rPr lang="en-US" smtClean="0"/>
              <a:t>9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CB32BE-F463-42D1-9EAA-8DF6CAAB0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792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514642" y="29265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>
                <a:latin typeface="Arial" panose="020B0604020202020204" pitchFamily="34" charset="0"/>
                <a:cs typeface="Arial" panose="020B0604020202020204" pitchFamily="34" charset="0"/>
              </a:rPr>
              <a:t>Diet Composition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2777166"/>
              </p:ext>
            </p:extLst>
          </p:nvPr>
        </p:nvGraphicFramePr>
        <p:xfrm>
          <a:off x="130398" y="477316"/>
          <a:ext cx="7184612" cy="5887368"/>
        </p:xfrm>
        <a:graphic>
          <a:graphicData uri="http://schemas.openxmlformats.org/drawingml/2006/table">
            <a:tbl>
              <a:tblPr/>
              <a:tblGrid>
                <a:gridCol w="1208350">
                  <a:extLst>
                    <a:ext uri="{9D8B030D-6E8A-4147-A177-3AD203B41FA5}">
                      <a16:colId xmlns:a16="http://schemas.microsoft.com/office/drawing/2014/main" val="1011726251"/>
                    </a:ext>
                  </a:extLst>
                </a:gridCol>
                <a:gridCol w="405600">
                  <a:extLst>
                    <a:ext uri="{9D8B030D-6E8A-4147-A177-3AD203B41FA5}">
                      <a16:colId xmlns:a16="http://schemas.microsoft.com/office/drawing/2014/main" val="2781395531"/>
                    </a:ext>
                  </a:extLst>
                </a:gridCol>
                <a:gridCol w="405600">
                  <a:extLst>
                    <a:ext uri="{9D8B030D-6E8A-4147-A177-3AD203B41FA5}">
                      <a16:colId xmlns:a16="http://schemas.microsoft.com/office/drawing/2014/main" val="4203705412"/>
                    </a:ext>
                  </a:extLst>
                </a:gridCol>
                <a:gridCol w="405600">
                  <a:extLst>
                    <a:ext uri="{9D8B030D-6E8A-4147-A177-3AD203B41FA5}">
                      <a16:colId xmlns:a16="http://schemas.microsoft.com/office/drawing/2014/main" val="3133045095"/>
                    </a:ext>
                  </a:extLst>
                </a:gridCol>
                <a:gridCol w="405600">
                  <a:extLst>
                    <a:ext uri="{9D8B030D-6E8A-4147-A177-3AD203B41FA5}">
                      <a16:colId xmlns:a16="http://schemas.microsoft.com/office/drawing/2014/main" val="1025617206"/>
                    </a:ext>
                  </a:extLst>
                </a:gridCol>
                <a:gridCol w="425067">
                  <a:extLst>
                    <a:ext uri="{9D8B030D-6E8A-4147-A177-3AD203B41FA5}">
                      <a16:colId xmlns:a16="http://schemas.microsoft.com/office/drawing/2014/main" val="2884757990"/>
                    </a:ext>
                  </a:extLst>
                </a:gridCol>
                <a:gridCol w="386133">
                  <a:extLst>
                    <a:ext uri="{9D8B030D-6E8A-4147-A177-3AD203B41FA5}">
                      <a16:colId xmlns:a16="http://schemas.microsoft.com/office/drawing/2014/main" val="1850805985"/>
                    </a:ext>
                  </a:extLst>
                </a:gridCol>
                <a:gridCol w="38078">
                  <a:extLst>
                    <a:ext uri="{9D8B030D-6E8A-4147-A177-3AD203B41FA5}">
                      <a16:colId xmlns:a16="http://schemas.microsoft.com/office/drawing/2014/main" val="2978291379"/>
                    </a:ext>
                  </a:extLst>
                </a:gridCol>
                <a:gridCol w="1221709">
                  <a:extLst>
                    <a:ext uri="{9D8B030D-6E8A-4147-A177-3AD203B41FA5}">
                      <a16:colId xmlns:a16="http://schemas.microsoft.com/office/drawing/2014/main" val="4194568673"/>
                    </a:ext>
                  </a:extLst>
                </a:gridCol>
                <a:gridCol w="660475">
                  <a:extLst>
                    <a:ext uri="{9D8B030D-6E8A-4147-A177-3AD203B41FA5}">
                      <a16:colId xmlns:a16="http://schemas.microsoft.com/office/drawing/2014/main" val="2711671669"/>
                    </a:ext>
                  </a:extLst>
                </a:gridCol>
                <a:gridCol w="405600">
                  <a:extLst>
                    <a:ext uri="{9D8B030D-6E8A-4147-A177-3AD203B41FA5}">
                      <a16:colId xmlns:a16="http://schemas.microsoft.com/office/drawing/2014/main" val="2673385543"/>
                    </a:ext>
                  </a:extLst>
                </a:gridCol>
                <a:gridCol w="257628">
                  <a:extLst>
                    <a:ext uri="{9D8B030D-6E8A-4147-A177-3AD203B41FA5}">
                      <a16:colId xmlns:a16="http://schemas.microsoft.com/office/drawing/2014/main" val="1269978870"/>
                    </a:ext>
                  </a:extLst>
                </a:gridCol>
                <a:gridCol w="147972">
                  <a:extLst>
                    <a:ext uri="{9D8B030D-6E8A-4147-A177-3AD203B41FA5}">
                      <a16:colId xmlns:a16="http://schemas.microsoft.com/office/drawing/2014/main" val="1644393029"/>
                    </a:ext>
                  </a:extLst>
                </a:gridCol>
                <a:gridCol w="405600">
                  <a:extLst>
                    <a:ext uri="{9D8B030D-6E8A-4147-A177-3AD203B41FA5}">
                      <a16:colId xmlns:a16="http://schemas.microsoft.com/office/drawing/2014/main" val="2534143133"/>
                    </a:ext>
                  </a:extLst>
                </a:gridCol>
                <a:gridCol w="405600">
                  <a:extLst>
                    <a:ext uri="{9D8B030D-6E8A-4147-A177-3AD203B41FA5}">
                      <a16:colId xmlns:a16="http://schemas.microsoft.com/office/drawing/2014/main" val="3101974490"/>
                    </a:ext>
                  </a:extLst>
                </a:gridCol>
              </a:tblGrid>
              <a:tr h="171163"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ctr" fontAlgn="b">
                        <a:tabLst>
                          <a:tab pos="60325" algn="l"/>
                        </a:tabLst>
                      </a:pP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7256213"/>
                  </a:ext>
                </a:extLst>
              </a:tr>
              <a:tr h="1711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ow Fat Diet (LFD)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1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1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1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estern Diet [WD]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3630916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12450K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1" i="0" u="sng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1" i="0" u="sng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12079B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791251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sng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sng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am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am 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428314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ein, lactic, 30 mesh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ein, lactic, 30 mesh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6192781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stine, L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hionine, DL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542442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rbohydrat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rch, corn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rbohydrat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rch, Corn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2773529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dex 1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dex 1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3035640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prietary form of maltodextrin.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prietary form of maltodextrin.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7575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cros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crose, Fine Granulated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256900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ber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lka Floc, Fcc20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ber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lka Floc, Fcc20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0419490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wdered cellulos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wdered cellulos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0052754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ybean oil, USP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utter, Anhydrous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3236523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rd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rn Oil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8818618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neral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026B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neral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001A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147937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cium Phosphate, dibasic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.5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3460985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cium Carbonate, Light USP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9871546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tamin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line Bitartrat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tamin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line Bitartrat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0871544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10001C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10001C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3942527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oxidant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oxidant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thoxyquin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1854332"/>
                  </a:ext>
                </a:extLst>
              </a:tr>
              <a:tr h="229485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lesterol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2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/g diet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2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lesterol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4160213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y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ue: FD&amp;C, #1 Alum Lak 35-42%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y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een: FD&amp;C, 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874961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d: FD&amp;C #40, Alum Lake 35-42%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3837530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1845879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tal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5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tal wt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tal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33 g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7562117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5243147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ories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sng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%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ories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ories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%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9246125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3097240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2162306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rbohydrat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rbohydrate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5470642"/>
                  </a:ext>
                </a:extLst>
              </a:tr>
              <a:tr h="126787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1953526"/>
                  </a:ext>
                </a:extLst>
              </a:tr>
              <a:tr h="22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ergy Density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82 kcal/g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ergy Density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7</a:t>
                      </a:r>
                    </a:p>
                  </a:txBody>
                  <a:tcPr marL="6339" marR="6339" marT="63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8040777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0" y="0"/>
            <a:ext cx="1317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1A Fig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4B139B5A-1757-4356-A6BA-7894A65369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6505397"/>
              </p:ext>
            </p:extLst>
          </p:nvPr>
        </p:nvGraphicFramePr>
        <p:xfrm>
          <a:off x="8161705" y="685789"/>
          <a:ext cx="3373069" cy="5453084"/>
        </p:xfrm>
        <a:graphic>
          <a:graphicData uri="http://schemas.openxmlformats.org/drawingml/2006/table">
            <a:tbl>
              <a:tblPr/>
              <a:tblGrid>
                <a:gridCol w="970181">
                  <a:extLst>
                    <a:ext uri="{9D8B030D-6E8A-4147-A177-3AD203B41FA5}">
                      <a16:colId xmlns:a16="http://schemas.microsoft.com/office/drawing/2014/main" val="3240365158"/>
                    </a:ext>
                  </a:extLst>
                </a:gridCol>
                <a:gridCol w="1060429">
                  <a:extLst>
                    <a:ext uri="{9D8B030D-6E8A-4147-A177-3AD203B41FA5}">
                      <a16:colId xmlns:a16="http://schemas.microsoft.com/office/drawing/2014/main" val="3230329271"/>
                    </a:ext>
                  </a:extLst>
                </a:gridCol>
                <a:gridCol w="1342459">
                  <a:extLst>
                    <a:ext uri="{9D8B030D-6E8A-4147-A177-3AD203B41FA5}">
                      <a16:colId xmlns:a16="http://schemas.microsoft.com/office/drawing/2014/main" val="336014182"/>
                    </a:ext>
                  </a:extLst>
                </a:gridCol>
              </a:tblGrid>
              <a:tr h="129728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earch Diet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earch Diets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1017263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imal #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2450K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12079B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688664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sng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ty Acid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sng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FD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sng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D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527812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0: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4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8026088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2: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8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4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8559361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4: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21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6694201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4:1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8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9334240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6: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.38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.01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6235608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6:1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7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2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6626182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8: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4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87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1232442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8:1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.45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.65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5624314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8:1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7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4664413"/>
                  </a:ext>
                </a:extLst>
              </a:tr>
              <a:tr h="1556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8:2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.4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4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729259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8:3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1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2717523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8:3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8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5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6017807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0: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8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7943641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0:1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1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0166076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0:2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1187422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0:3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6542297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0:3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2662130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0:4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8128233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2: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6920718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2:1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828751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0:5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4315617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4: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5443378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2:2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2998514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2:3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3069519"/>
                  </a:ext>
                </a:extLst>
              </a:tr>
              <a:tr h="1556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4:1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6174429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2:4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4353516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2:5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6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6671665"/>
                  </a:ext>
                </a:extLst>
              </a:tr>
              <a:tr h="1055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2:5,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8796774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2:6,</a:t>
                      </a:r>
                      <a:r>
                        <a:rPr lang="el-GR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ω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7637203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tal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.00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7615401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9780947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otal </a:t>
                      </a:r>
                      <a:r>
                        <a:rPr lang="el-GR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ω</a:t>
                      </a:r>
                      <a:r>
                        <a:rPr lang="el-GR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6 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UFA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36.2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5.65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5590436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otal </a:t>
                      </a:r>
                      <a:r>
                        <a:rPr lang="el-GR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ω</a:t>
                      </a:r>
                      <a:r>
                        <a:rPr lang="el-GR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3 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UFA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3.92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0.49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8281662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1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6405579"/>
                  </a:ext>
                </a:extLst>
              </a:tr>
              <a:tr h="1297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atio: </a:t>
                      </a:r>
                      <a:r>
                        <a:rPr lang="el-GR" sz="9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ω6/ω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9.25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11.43</a:t>
                      </a:r>
                    </a:p>
                  </a:txBody>
                  <a:tcPr marL="5666" marR="5666" marT="566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694643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0BB03309-3392-4B19-9D22-876BAE6D7E5D}"/>
              </a:ext>
            </a:extLst>
          </p:cNvPr>
          <p:cNvSpPr txBox="1"/>
          <p:nvPr/>
        </p:nvSpPr>
        <p:spPr>
          <a:xfrm>
            <a:off x="8454267" y="84194"/>
            <a:ext cx="27879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et Fatty Acid Composition</a:t>
            </a:r>
          </a:p>
          <a:p>
            <a:r>
              <a:rPr lang="en-US" u="sng" dirty="0"/>
              <a:t>               Mole %</a:t>
            </a:r>
          </a:p>
        </p:txBody>
      </p:sp>
    </p:spTree>
    <p:extLst>
      <p:ext uri="{BB962C8B-B14F-4D97-AF65-F5344CB8AC3E}">
        <p14:creationId xmlns:p14="http://schemas.microsoft.com/office/powerpoint/2010/main" val="41146135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199" y="990600"/>
            <a:ext cx="9973733" cy="700088"/>
          </a:xfrm>
        </p:spPr>
        <p:txBody>
          <a:bodyPr>
            <a:normAutofit fontScale="90000"/>
          </a:bodyPr>
          <a:lstStyle/>
          <a:p>
            <a:r>
              <a:rPr lang="en-US" sz="4000" dirty="0">
                <a:latin typeface="Arial" panose="020B0604020202020204" pitchFamily="34" charset="0"/>
                <a:cs typeface="Arial" panose="020B0604020202020204" pitchFamily="34" charset="0"/>
              </a:rPr>
              <a:t>Histopathology-1: Steatosis and Inflammatio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>
            <a:off x="2995083" y="1997075"/>
            <a:ext cx="5801784" cy="4351338"/>
          </a:xfrm>
          <a:prstGeom prst="rect">
            <a:avLst/>
          </a:prstGeom>
        </p:spPr>
      </p:pic>
      <p:sp>
        <p:nvSpPr>
          <p:cNvPr id="7" name="Right Arrow 6"/>
          <p:cNvSpPr/>
          <p:nvPr/>
        </p:nvSpPr>
        <p:spPr>
          <a:xfrm rot="20636159">
            <a:off x="2733677" y="3625586"/>
            <a:ext cx="2085975" cy="13335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ight Arrow 7"/>
          <p:cNvSpPr/>
          <p:nvPr/>
        </p:nvSpPr>
        <p:spPr>
          <a:xfrm rot="10800000">
            <a:off x="8496299" y="3467100"/>
            <a:ext cx="1209675" cy="1143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ight Arrow 8"/>
          <p:cNvSpPr/>
          <p:nvPr/>
        </p:nvSpPr>
        <p:spPr>
          <a:xfrm rot="10800000">
            <a:off x="6220746" y="4975227"/>
            <a:ext cx="3286125" cy="1524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783720" y="3224367"/>
            <a:ext cx="1645002" cy="584775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Macrovesicula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teatosis [MAS]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70757" y="2752522"/>
            <a:ext cx="1552028" cy="584775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Microvesicula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teatosis [MIS]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506871" y="4312763"/>
            <a:ext cx="2604934" cy="1323439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u="sng" dirty="0">
                <a:latin typeface="Arial" panose="020B0604020202020204" pitchFamily="34" charset="0"/>
                <a:cs typeface="Arial" panose="020B0604020202020204" pitchFamily="34" charset="0"/>
              </a:rPr>
              <a:t>Foci of inflammation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ith at least 5 granulocytes, disruption of hepatic plates or hepatocyte loss, &amp; increased eosinophilia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995083" y="6348413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 &amp; E 400x</a:t>
            </a:r>
          </a:p>
        </p:txBody>
      </p:sp>
      <p:sp>
        <p:nvSpPr>
          <p:cNvPr id="14" name="Right Arrow 13"/>
          <p:cNvSpPr/>
          <p:nvPr/>
        </p:nvSpPr>
        <p:spPr>
          <a:xfrm>
            <a:off x="2428875" y="2981325"/>
            <a:ext cx="2085975" cy="13335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551275" y="3686925"/>
            <a:ext cx="1221808" cy="584775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epatocyte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77485" y="231011"/>
            <a:ext cx="17107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1B Fig</a:t>
            </a:r>
          </a:p>
        </p:txBody>
      </p:sp>
    </p:spTree>
    <p:extLst>
      <p:ext uri="{BB962C8B-B14F-4D97-AF65-F5344CB8AC3E}">
        <p14:creationId xmlns:p14="http://schemas.microsoft.com/office/powerpoint/2010/main" val="33879154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R18-682-89-000.ti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725503" y="1424619"/>
            <a:ext cx="4876800" cy="36576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450666" y="5166087"/>
            <a:ext cx="342053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acrosteatosis: Score = 3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icrosteatosis:   Score = 1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H&amp;E, 400x)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e image shows displacement of nuclei by large lipid droplets</a:t>
            </a:r>
          </a:p>
        </p:txBody>
      </p:sp>
      <p:pic>
        <p:nvPicPr>
          <p:cNvPr id="4" name="Picture 3" descr="R18-682-54-001.tif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98813" y="1424619"/>
            <a:ext cx="4876800" cy="3657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59679" y="5166893"/>
            <a:ext cx="453741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acrosteatosis: Score = 0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icrosteatosis:  Score = 3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H&amp;E, 400x)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e image shows “rosettes” of vacuoles around hepatocyte nuclei typical of micro 3.</a:t>
            </a: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2847974" y="639857"/>
            <a:ext cx="6163733" cy="700088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Histopathology-2: Steatosi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104216" y="5128612"/>
            <a:ext cx="1432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 &amp; E 400x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344150" y="5082219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 &amp; E 400x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0" y="0"/>
            <a:ext cx="17107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1C Fig</a:t>
            </a:r>
          </a:p>
        </p:txBody>
      </p:sp>
    </p:spTree>
    <p:extLst>
      <p:ext uri="{BB962C8B-B14F-4D97-AF65-F5344CB8AC3E}">
        <p14:creationId xmlns:p14="http://schemas.microsoft.com/office/powerpoint/2010/main" val="39769074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415" y="1567542"/>
            <a:ext cx="4884057" cy="367740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0628" y="1567542"/>
            <a:ext cx="4884058" cy="367740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712898" y="2093091"/>
            <a:ext cx="4683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65646" y="3871754"/>
            <a:ext cx="4571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V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874638" y="1584798"/>
            <a:ext cx="4683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0974659" y="4726519"/>
            <a:ext cx="4571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V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127940" y="5466320"/>
            <a:ext cx="19078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Macrosteatosi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700889" y="5405970"/>
            <a:ext cx="164019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Centrilobular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FIbrosis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Arrow Connector 15"/>
          <p:cNvCxnSpPr/>
          <p:nvPr/>
        </p:nvCxnSpPr>
        <p:spPr>
          <a:xfrm flipH="1" flipV="1">
            <a:off x="8559090" y="4289242"/>
            <a:ext cx="578552" cy="111672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V="1">
            <a:off x="7476067" y="3556000"/>
            <a:ext cx="59732" cy="184098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flipH="1" flipV="1">
            <a:off x="8263467" y="2870200"/>
            <a:ext cx="874176" cy="254423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 flipV="1">
            <a:off x="9072700" y="3871754"/>
            <a:ext cx="64942" cy="154268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flipV="1">
            <a:off x="7476067" y="4377267"/>
            <a:ext cx="368268" cy="101971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V="1">
            <a:off x="7476067" y="3810000"/>
            <a:ext cx="230586" cy="158698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itle 1"/>
          <p:cNvSpPr txBox="1">
            <a:spLocks/>
          </p:cNvSpPr>
          <p:nvPr/>
        </p:nvSpPr>
        <p:spPr>
          <a:xfrm>
            <a:off x="1036418" y="800998"/>
            <a:ext cx="10598534" cy="700088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Histopathology-3: Fibrosis; Picro Sirius Red Stain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14842" y="5227709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R 40x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0379308" y="5212320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R 100x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6532" y="93131"/>
            <a:ext cx="17107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1D Fig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5F4A397-BF22-4D3E-B291-B6905B316416}"/>
              </a:ext>
            </a:extLst>
          </p:cNvPr>
          <p:cNvSpPr/>
          <p:nvPr/>
        </p:nvSpPr>
        <p:spPr>
          <a:xfrm>
            <a:off x="1587062" y="2127196"/>
            <a:ext cx="2207172" cy="168280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DD06F8FA-FA32-4CDF-8511-B5667DB7C27C}"/>
              </a:ext>
            </a:extLst>
          </p:cNvPr>
          <p:cNvCxnSpPr/>
          <p:nvPr/>
        </p:nvCxnSpPr>
        <p:spPr>
          <a:xfrm flipV="1">
            <a:off x="3794234" y="1567542"/>
            <a:ext cx="2686394" cy="55965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26FBCE-3C83-4DBB-8B8E-7C7B56D9B9E6}"/>
              </a:ext>
            </a:extLst>
          </p:cNvPr>
          <p:cNvCxnSpPr>
            <a:cxnSpLocks/>
          </p:cNvCxnSpPr>
          <p:nvPr/>
        </p:nvCxnSpPr>
        <p:spPr>
          <a:xfrm>
            <a:off x="3794234" y="3810000"/>
            <a:ext cx="2686393" cy="143495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FA61A261-055A-4F14-A9A9-5AE9E7B68D11}"/>
              </a:ext>
            </a:extLst>
          </p:cNvPr>
          <p:cNvSpPr txBox="1"/>
          <p:nvPr/>
        </p:nvSpPr>
        <p:spPr>
          <a:xfrm>
            <a:off x="2928443" y="5492804"/>
            <a:ext cx="180472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V: central vein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V: portal vein</a:t>
            </a:r>
          </a:p>
        </p:txBody>
      </p:sp>
    </p:spTree>
    <p:extLst>
      <p:ext uri="{BB962C8B-B14F-4D97-AF65-F5344CB8AC3E}">
        <p14:creationId xmlns:p14="http://schemas.microsoft.com/office/powerpoint/2010/main" val="30139112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ABB95B08-3BB9-474F-97AF-4EE199A57D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0803624"/>
              </p:ext>
            </p:extLst>
          </p:nvPr>
        </p:nvGraphicFramePr>
        <p:xfrm>
          <a:off x="1104863" y="786869"/>
          <a:ext cx="41811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4CF05F97-901C-46E8-89AC-A26E07C08BC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6310157"/>
              </p:ext>
            </p:extLst>
          </p:nvPr>
        </p:nvGraphicFramePr>
        <p:xfrm>
          <a:off x="1115809" y="3908469"/>
          <a:ext cx="420821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3103518-03BE-45C0-8080-4F1FBBBD6B93}"/>
              </a:ext>
            </a:extLst>
          </p:cNvPr>
          <p:cNvSpPr txBox="1"/>
          <p:nvPr/>
        </p:nvSpPr>
        <p:spPr>
          <a:xfrm rot="16200000">
            <a:off x="-260785" y="4716078"/>
            <a:ext cx="18229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ood Consumption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ram/day/mous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CC80B16-32B4-4BDD-B600-2AAFE6FB50E0}"/>
              </a:ext>
            </a:extLst>
          </p:cNvPr>
          <p:cNvSpPr txBox="1"/>
          <p:nvPr/>
        </p:nvSpPr>
        <p:spPr>
          <a:xfrm rot="16200000">
            <a:off x="-260785" y="1652535"/>
            <a:ext cx="18229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ood Consumption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ram/day/mous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AD5E64-9068-4131-A98F-8747DFF8BD6E}"/>
              </a:ext>
            </a:extLst>
          </p:cNvPr>
          <p:cNvSpPr txBox="1"/>
          <p:nvPr/>
        </p:nvSpPr>
        <p:spPr>
          <a:xfrm>
            <a:off x="1949111" y="3277899"/>
            <a:ext cx="3029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eeks on Purified Diet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1CB5A95-78DB-4249-ABAB-010474B94C84}"/>
              </a:ext>
            </a:extLst>
          </p:cNvPr>
          <p:cNvSpPr txBox="1"/>
          <p:nvPr/>
        </p:nvSpPr>
        <p:spPr>
          <a:xfrm>
            <a:off x="2072440" y="6472781"/>
            <a:ext cx="30500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eeks on Purified Diet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331151-0F0C-46F4-A336-E67E443980A1}"/>
              </a:ext>
            </a:extLst>
          </p:cNvPr>
          <p:cNvSpPr txBox="1"/>
          <p:nvPr/>
        </p:nvSpPr>
        <p:spPr>
          <a:xfrm>
            <a:off x="0" y="-86346"/>
            <a:ext cx="13292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1E Fig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FD19AA0-6D9E-4156-8B98-B0219E726346}"/>
              </a:ext>
            </a:extLst>
          </p:cNvPr>
          <p:cNvSpPr txBox="1"/>
          <p:nvPr/>
        </p:nvSpPr>
        <p:spPr>
          <a:xfrm>
            <a:off x="6978870" y="283400"/>
            <a:ext cx="42791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B.  Cumulative Calorie Consumpt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6217068-2078-4035-ACB6-A3ABEF20EFD2}"/>
              </a:ext>
            </a:extLst>
          </p:cNvPr>
          <p:cNvSpPr txBox="1"/>
          <p:nvPr/>
        </p:nvSpPr>
        <p:spPr>
          <a:xfrm rot="16200000">
            <a:off x="6029205" y="1551502"/>
            <a:ext cx="18758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Cumulative calorie 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sumption, Kcal</a:t>
            </a:r>
          </a:p>
        </p:txBody>
      </p:sp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28225FC6-8F36-41A8-B8A4-163A6796B1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5394939"/>
              </p:ext>
            </p:extLst>
          </p:nvPr>
        </p:nvGraphicFramePr>
        <p:xfrm>
          <a:off x="6835846" y="688653"/>
          <a:ext cx="4181110" cy="28610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D1B24E54-790C-4467-8C94-AF615BC248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0200040"/>
              </p:ext>
            </p:extLst>
          </p:nvPr>
        </p:nvGraphicFramePr>
        <p:xfrm>
          <a:off x="6830558" y="3743136"/>
          <a:ext cx="4318487" cy="29815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9F669386-B7B1-4CC3-A329-02DAF486A007}"/>
              </a:ext>
            </a:extLst>
          </p:cNvPr>
          <p:cNvSpPr txBox="1"/>
          <p:nvPr/>
        </p:nvSpPr>
        <p:spPr>
          <a:xfrm rot="16200000">
            <a:off x="6040953" y="4629647"/>
            <a:ext cx="18758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Cumulative calorie 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sumption, Kca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0348F0A-3D75-4588-B9D8-AD9928C78351}"/>
              </a:ext>
            </a:extLst>
          </p:cNvPr>
          <p:cNvSpPr txBox="1"/>
          <p:nvPr/>
        </p:nvSpPr>
        <p:spPr>
          <a:xfrm>
            <a:off x="9365197" y="6447714"/>
            <a:ext cx="8301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F70CC21-D2B4-4840-90CE-BA9AE8631AF6}"/>
              </a:ext>
            </a:extLst>
          </p:cNvPr>
          <p:cNvSpPr txBox="1"/>
          <p:nvPr/>
        </p:nvSpPr>
        <p:spPr>
          <a:xfrm>
            <a:off x="9267942" y="3301961"/>
            <a:ext cx="8301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196C1AD-C304-4B19-83E1-AC870980855C}"/>
              </a:ext>
            </a:extLst>
          </p:cNvPr>
          <p:cNvSpPr txBox="1"/>
          <p:nvPr/>
        </p:nvSpPr>
        <p:spPr>
          <a:xfrm>
            <a:off x="1207802" y="311900"/>
            <a:ext cx="3501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A.  Daily Food Consumptio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F1B47C7-3F11-4576-B481-51378489B50E}"/>
              </a:ext>
            </a:extLst>
          </p:cNvPr>
          <p:cNvSpPr txBox="1"/>
          <p:nvPr/>
        </p:nvSpPr>
        <p:spPr>
          <a:xfrm>
            <a:off x="8886770" y="517591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A98AAD3-7618-4979-9389-4FAEABE6D78D}"/>
              </a:ext>
            </a:extLst>
          </p:cNvPr>
          <p:cNvSpPr txBox="1"/>
          <p:nvPr/>
        </p:nvSpPr>
        <p:spPr>
          <a:xfrm>
            <a:off x="8868482" y="217668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065041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4</TotalTime>
  <Words>588</Words>
  <Application>Microsoft Office PowerPoint</Application>
  <PresentationFormat>Widescreen</PresentationFormat>
  <Paragraphs>28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Histopathology-1: Steatosis and Inflammation</vt:lpstr>
      <vt:lpstr>PowerPoint Presentation</vt:lpstr>
      <vt:lpstr>PowerPoint Presentation</vt:lpstr>
      <vt:lpstr>PowerPoint Presentation</vt:lpstr>
    </vt:vector>
  </TitlesOfParts>
  <Company>Oregon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mp, Donald</dc:creator>
  <cp:lastModifiedBy>Jump, Donald</cp:lastModifiedBy>
  <cp:revision>64</cp:revision>
  <dcterms:created xsi:type="dcterms:W3CDTF">2021-08-19T21:14:14Z</dcterms:created>
  <dcterms:modified xsi:type="dcterms:W3CDTF">2023-09-23T23:56:08Z</dcterms:modified>
</cp:coreProperties>
</file>